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drawings/drawing5.xml" ContentType="application/vnd.openxmlformats-officedocument.drawingml.chartshapes+xml"/>
  <Override PartName="/ppt/charts/chart7.xml" ContentType="application/vnd.openxmlformats-officedocument.drawingml.chart+xml"/>
  <Override PartName="/ppt/drawings/drawing6.xml" ContentType="application/vnd.openxmlformats-officedocument.drawingml.chartshapes+xml"/>
  <Override PartName="/ppt/charts/chart8.xml" ContentType="application/vnd.openxmlformats-officedocument.drawingml.chart+xml"/>
  <Override PartName="/ppt/drawings/drawing7.xml" ContentType="application/vnd.openxmlformats-officedocument.drawingml.chartshapes+xml"/>
  <Override PartName="/ppt/charts/chart9.xml" ContentType="application/vnd.openxmlformats-officedocument.drawingml.chart+xml"/>
  <Override PartName="/ppt/drawings/drawing8.xml" ContentType="application/vnd.openxmlformats-officedocument.drawingml.chartshapes+xml"/>
  <Override PartName="/ppt/charts/chart10.xml" ContentType="application/vnd.openxmlformats-officedocument.drawingml.chart+xml"/>
  <Override PartName="/ppt/drawings/drawing9.xml" ContentType="application/vnd.openxmlformats-officedocument.drawingml.chartshapes+xml"/>
  <Override PartName="/ppt/charts/chart11.xml" ContentType="application/vnd.openxmlformats-officedocument.drawingml.chart+xml"/>
  <Override PartName="/ppt/drawings/drawing10.xml" ContentType="application/vnd.openxmlformats-officedocument.drawingml.chartshapes+xml"/>
  <Override PartName="/ppt/charts/chart12.xml" ContentType="application/vnd.openxmlformats-officedocument.drawingml.chart+xml"/>
  <Override PartName="/ppt/drawings/drawing11.xml" ContentType="application/vnd.openxmlformats-officedocument.drawingml.chartshapes+xml"/>
  <Override PartName="/ppt/charts/chart13.xml" ContentType="application/vnd.openxmlformats-officedocument.drawingml.chart+xml"/>
  <Override PartName="/ppt/drawings/drawing12.xml" ContentType="application/vnd.openxmlformats-officedocument.drawingml.chartshapes+xml"/>
  <Override PartName="/ppt/charts/chart14.xml" ContentType="application/vnd.openxmlformats-officedocument.drawingml.chart+xml"/>
  <Override PartName="/ppt/drawings/drawing13.xml" ContentType="application/vnd.openxmlformats-officedocument.drawingml.chartshapes+xml"/>
  <Override PartName="/ppt/charts/chart15.xml" ContentType="application/vnd.openxmlformats-officedocument.drawingml.chart+xml"/>
  <Override PartName="/ppt/drawings/drawing14.xml" ContentType="application/vnd.openxmlformats-officedocument.drawingml.chartshapes+xml"/>
  <Override PartName="/ppt/charts/chart16.xml" ContentType="application/vnd.openxmlformats-officedocument.drawingml.chart+xml"/>
  <Override PartName="/ppt/drawings/drawing15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  <p:sldId id="264" r:id="rId4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八代田　真人" initials="八代田　真人" lastIdx="2" clrIdx="0">
    <p:extLst>
      <p:ext uri="{19B8F6BF-5375-455C-9EA6-DF929625EA0E}">
        <p15:presenceInfo xmlns:p15="http://schemas.microsoft.com/office/powerpoint/2012/main" userId="S::yayo@gifu-u.ac.jp::1df05230-7a49-4426-abad-2e901f659fda" providerId="AD"/>
      </p:ext>
    </p:extLst>
  </p:cmAuthor>
  <p:cmAuthor id="2" name="Noriaki Nakajima" initials="u" lastIdx="1" clrIdx="1">
    <p:extLst>
      <p:ext uri="{19B8F6BF-5375-455C-9EA6-DF929625EA0E}">
        <p15:presenceInfo xmlns:p15="http://schemas.microsoft.com/office/powerpoint/2012/main" userId="Noriaki Nakajim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FE1A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1" d="100"/>
          <a:sy n="101" d="100"/>
        </p:scale>
        <p:origin x="29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N10\Documents\&#30740;&#31350;\&#30740;&#31350;&#20869;&#23481;\171013%20&#38263;&#26399;&#25918;&#29287;&#35430;&#39443;\&#27671;&#36074;&#12486;&#12473;&#12488;\Temperament%20test%20result.xlsx" TargetMode="External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9.xml"/><Relationship Id="rId1" Type="http://schemas.openxmlformats.org/officeDocument/2006/relationships/oleObject" Target="file:///C:\Users\N10\Documents\&#30740;&#31350;\&#30740;&#31350;&#20869;&#23481;\171013%20&#38263;&#26399;&#25918;&#29287;&#35430;&#39443;\&#27671;&#36074;&#12486;&#12473;&#12488;\Temperament%20test%20result.xlsx" TargetMode="External"/></Relationships>
</file>

<file path=ppt/charts/_rels/chart1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0.xml"/><Relationship Id="rId1" Type="http://schemas.openxmlformats.org/officeDocument/2006/relationships/oleObject" Target="file:///C:\Users\N10\Documents\&#30740;&#31350;\&#30740;&#31350;&#20869;&#23481;\171013%20&#38263;&#26399;&#25918;&#29287;&#35430;&#39443;\&#27671;&#36074;&#12486;&#12473;&#12488;\Temperament%20test%20result.xlsx" TargetMode="External"/></Relationships>
</file>

<file path=ppt/charts/_rels/chart1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1.xml"/><Relationship Id="rId1" Type="http://schemas.openxmlformats.org/officeDocument/2006/relationships/oleObject" Target="file:///C:\Users\N10\Documents\&#30740;&#31350;\&#30740;&#31350;&#20869;&#23481;\171013%20&#38263;&#26399;&#25918;&#29287;&#35430;&#39443;\&#27671;&#36074;&#12486;&#12473;&#12488;\Temperament%20test%20result.xlsx" TargetMode="External"/></Relationships>
</file>

<file path=ppt/charts/_rels/chart1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2.xml"/><Relationship Id="rId1" Type="http://schemas.openxmlformats.org/officeDocument/2006/relationships/oleObject" Target="file:///C:\Users\N10\Documents\&#30740;&#31350;\&#30740;&#31350;&#20869;&#23481;\171013%20&#38263;&#26399;&#25918;&#29287;&#35430;&#39443;\&#27671;&#36074;&#12486;&#12473;&#12488;\Temperament%20test%20result.xlsx" TargetMode="External"/></Relationships>
</file>

<file path=ppt/charts/_rels/chart1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3.xml"/><Relationship Id="rId1" Type="http://schemas.openxmlformats.org/officeDocument/2006/relationships/oleObject" Target="file:///C:\Users\N10\Documents\&#30740;&#31350;\&#30740;&#31350;&#20869;&#23481;\171013%20&#38263;&#26399;&#25918;&#29287;&#35430;&#39443;\&#27671;&#36074;&#12486;&#12473;&#12488;\Temperament%20test%20result.xlsx" TargetMode="External"/></Relationships>
</file>

<file path=ppt/charts/_rels/chart1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4.xml"/><Relationship Id="rId1" Type="http://schemas.openxmlformats.org/officeDocument/2006/relationships/oleObject" Target="file:///C:\Users\N10\Documents\&#30740;&#31350;\&#30740;&#31350;&#20869;&#23481;\171013%20&#38263;&#26399;&#25918;&#29287;&#35430;&#39443;\&#27671;&#36074;&#12486;&#12473;&#12488;\Temperament%20test%20result.xlsx" TargetMode="External"/></Relationships>
</file>

<file path=ppt/charts/_rels/chart1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5.xml"/><Relationship Id="rId1" Type="http://schemas.openxmlformats.org/officeDocument/2006/relationships/oleObject" Target="file:///C:\Users\N10\Documents\&#30740;&#31350;\&#30740;&#31350;&#20869;&#23481;\171013%20&#38263;&#26399;&#25918;&#29287;&#35430;&#39443;\&#27671;&#36074;&#12486;&#12473;&#12488;\Temperament%20test%20result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N10\Documents\&#30740;&#31350;\&#30740;&#31350;&#20869;&#23481;\171013%20&#38263;&#26399;&#25918;&#29287;&#35430;&#39443;\&#27671;&#36074;&#12486;&#12473;&#12488;\Temperament%20test%20result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C:\Users\N10\Documents\&#30740;&#31350;\&#30740;&#31350;&#20869;&#23481;\171013%20&#38263;&#26399;&#25918;&#29287;&#35430;&#39443;\&#27671;&#36074;&#12486;&#12473;&#12488;\Temperament%20test%20result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C:\Users\N10\Documents\&#30740;&#31350;\&#30740;&#31350;&#20869;&#23481;\171013%20&#38263;&#26399;&#25918;&#29287;&#35430;&#39443;\&#27671;&#36074;&#12486;&#12473;&#12488;\Temperament%20test%20result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10\Documents\&#30740;&#31350;\&#30740;&#31350;&#20869;&#23481;\171013%20&#38263;&#26399;&#25918;&#29287;&#35430;&#39443;\&#27671;&#36074;&#12486;&#12473;&#12488;\Temperament%20test%20result.xlsx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C:\Users\N10\Documents\&#30740;&#31350;\&#30740;&#31350;&#20869;&#23481;\171013%20&#38263;&#26399;&#25918;&#29287;&#35430;&#39443;\&#27671;&#36074;&#12486;&#12473;&#12488;\Temperament%20test%20result.xlsx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oleObject" Target="file:///C:\Users\N10\Documents\&#30740;&#31350;\&#30740;&#31350;&#20869;&#23481;\171013%20&#38263;&#26399;&#25918;&#29287;&#35430;&#39443;\&#27671;&#36074;&#12486;&#12473;&#12488;\Temperament%20test%20result.xlsx" TargetMode="Externa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7.xml"/><Relationship Id="rId1" Type="http://schemas.openxmlformats.org/officeDocument/2006/relationships/oleObject" Target="file:///C:\Users\N10\Documents\&#30740;&#31350;\&#30740;&#31350;&#20869;&#23481;\171013%20&#38263;&#26399;&#25918;&#29287;&#35430;&#39443;\&#27671;&#36074;&#12486;&#12473;&#12488;\Temperament%20test%20result.xlsx" TargetMode="Externa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8.xml"/><Relationship Id="rId1" Type="http://schemas.openxmlformats.org/officeDocument/2006/relationships/oleObject" Target="file:///C:\Users\N10\Documents\&#30740;&#31350;\&#30740;&#31350;&#20869;&#23481;\171013%20&#38263;&#26399;&#25918;&#29287;&#35430;&#39443;\&#27671;&#36074;&#12486;&#12473;&#12488;\Temperament%20test%20resul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B) Head movement</a:t>
            </a:r>
            <a:endParaRPr lang="ja-JP" sz="1200" dirty="0"/>
          </a:p>
        </c:rich>
      </c:tx>
      <c:layout>
        <c:manualLayout>
          <c:xMode val="edge"/>
          <c:yMode val="edge"/>
          <c:x val="0.25799574620908899"/>
          <c:y val="2.863217128801935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904654639689025"/>
          <c:y val="0.1304614358329822"/>
          <c:w val="0.75128263397455053"/>
          <c:h val="0.6980031991276773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aper (average) (2)'!$D$4</c:f>
              <c:strCache>
                <c:ptCount val="1"/>
                <c:pt idx="0">
                  <c:v>C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7:$AB$7</c:f>
                <c:numCache>
                  <c:formatCode>General</c:formatCode>
                  <c:ptCount val="5"/>
                  <c:pt idx="0">
                    <c:v>0.56825757070774396</c:v>
                  </c:pt>
                  <c:pt idx="1">
                    <c:v>0.62081935107297248</c:v>
                  </c:pt>
                  <c:pt idx="2">
                    <c:v>0.23935677693908453</c:v>
                  </c:pt>
                  <c:pt idx="3">
                    <c:v>0.3715816419936091</c:v>
                  </c:pt>
                  <c:pt idx="4">
                    <c:v>0.38133537295491843</c:v>
                  </c:pt>
                </c:numCache>
              </c:numRef>
            </c:plus>
            <c:minus>
              <c:numRef>
                <c:f>'For paper (average) (2)'!$X$7:$AB$7</c:f>
                <c:numCache>
                  <c:formatCode>General</c:formatCode>
                  <c:ptCount val="5"/>
                  <c:pt idx="0">
                    <c:v>0.56825757070774396</c:v>
                  </c:pt>
                  <c:pt idx="1">
                    <c:v>0.62081935107297248</c:v>
                  </c:pt>
                  <c:pt idx="2">
                    <c:v>0.23935677693908453</c:v>
                  </c:pt>
                  <c:pt idx="3">
                    <c:v>0.3715816419936091</c:v>
                  </c:pt>
                  <c:pt idx="4">
                    <c:v>0.3813353729549184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D$7:$H$7</c:f>
              <c:numCache>
                <c:formatCode>General</c:formatCode>
                <c:ptCount val="5"/>
                <c:pt idx="0">
                  <c:v>7</c:v>
                </c:pt>
                <c:pt idx="1">
                  <c:v>7</c:v>
                </c:pt>
                <c:pt idx="2">
                  <c:v>6.625</c:v>
                </c:pt>
                <c:pt idx="3">
                  <c:v>7.2374999999999998</c:v>
                </c:pt>
                <c:pt idx="4">
                  <c:v>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823-4CFA-8610-C14099C49720}"/>
            </c:ext>
          </c:extLst>
        </c:ser>
        <c:ser>
          <c:idx val="1"/>
          <c:order val="1"/>
          <c:tx>
            <c:strRef>
              <c:f>'For paper (average) (2)'!$I$4</c:f>
              <c:strCache>
                <c:ptCount val="1"/>
                <c:pt idx="0">
                  <c:v>G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AC$7:$AG$7</c:f>
                <c:numCache>
                  <c:formatCode>General</c:formatCode>
                  <c:ptCount val="5"/>
                  <c:pt idx="0">
                    <c:v>0.34871191548325386</c:v>
                  </c:pt>
                  <c:pt idx="1">
                    <c:v>0.40969500851242963</c:v>
                  </c:pt>
                  <c:pt idx="2">
                    <c:v>0.23579652245103133</c:v>
                  </c:pt>
                  <c:pt idx="3">
                    <c:v>0.57844619455918245</c:v>
                  </c:pt>
                  <c:pt idx="4">
                    <c:v>0.41970227542866623</c:v>
                  </c:pt>
                </c:numCache>
              </c:numRef>
            </c:plus>
            <c:minus>
              <c:numRef>
                <c:f>'For paper (average) (2)'!$AC$7:$AG$7</c:f>
                <c:numCache>
                  <c:formatCode>General</c:formatCode>
                  <c:ptCount val="5"/>
                  <c:pt idx="0">
                    <c:v>0.34871191548325386</c:v>
                  </c:pt>
                  <c:pt idx="1">
                    <c:v>0.40969500851242963</c:v>
                  </c:pt>
                  <c:pt idx="2">
                    <c:v>0.23579652245103133</c:v>
                  </c:pt>
                  <c:pt idx="3">
                    <c:v>0.57844619455918245</c:v>
                  </c:pt>
                  <c:pt idx="4">
                    <c:v>0.4197022754286662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I$7:$M$7</c:f>
              <c:numCache>
                <c:formatCode>General</c:formatCode>
                <c:ptCount val="5"/>
                <c:pt idx="0">
                  <c:v>6.9599999999999991</c:v>
                </c:pt>
                <c:pt idx="1">
                  <c:v>1.9400000000000002</c:v>
                </c:pt>
                <c:pt idx="2">
                  <c:v>2.16</c:v>
                </c:pt>
                <c:pt idx="3">
                  <c:v>2.89</c:v>
                </c:pt>
                <c:pt idx="4">
                  <c:v>2.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823-4CFA-8610-C14099C497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076800"/>
        <c:axId val="84077376"/>
      </c:scatterChart>
      <c:valAx>
        <c:axId val="84076800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84077376"/>
        <c:crosses val="autoZero"/>
        <c:crossBetween val="midCat"/>
        <c:majorUnit val="20"/>
      </c:valAx>
      <c:valAx>
        <c:axId val="84077376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VA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84076800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  <c:userShapes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 b="1"/>
            </a:pPr>
            <a:r>
              <a:rPr lang="en-US" sz="1200" b="1" dirty="0"/>
              <a:t>D) Rope tension</a:t>
            </a:r>
            <a:endParaRPr lang="ja-JP" sz="1200" b="1" dirty="0"/>
          </a:p>
        </c:rich>
      </c:tx>
      <c:layout>
        <c:manualLayout>
          <c:xMode val="edge"/>
          <c:yMode val="edge"/>
          <c:x val="0.2746074846793079"/>
          <c:y val="6.366981819512239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904654639689025"/>
          <c:y val="0.1304614358329822"/>
          <c:w val="0.75128263397455053"/>
          <c:h val="0.6980031991276773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aper (average) (2)'!$D$4</c:f>
              <c:strCache>
                <c:ptCount val="1"/>
                <c:pt idx="0">
                  <c:v>C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20:$AB$20</c:f>
                <c:numCache>
                  <c:formatCode>General</c:formatCode>
                  <c:ptCount val="5"/>
                  <c:pt idx="0">
                    <c:v>0.9289330797569143</c:v>
                  </c:pt>
                  <c:pt idx="1">
                    <c:v>0.50389110926865932</c:v>
                  </c:pt>
                  <c:pt idx="2">
                    <c:v>0.27913557040740378</c:v>
                  </c:pt>
                  <c:pt idx="3">
                    <c:v>0.34179367558026397</c:v>
                  </c:pt>
                  <c:pt idx="4">
                    <c:v>0.49916597106239391</c:v>
                  </c:pt>
                </c:numCache>
              </c:numRef>
            </c:plus>
            <c:minus>
              <c:numRef>
                <c:f>'For paper (average) (2)'!$X$20:$AB$20</c:f>
                <c:numCache>
                  <c:formatCode>General</c:formatCode>
                  <c:ptCount val="5"/>
                  <c:pt idx="0">
                    <c:v>0.9289330797569143</c:v>
                  </c:pt>
                  <c:pt idx="1">
                    <c:v>0.50389110926865932</c:v>
                  </c:pt>
                  <c:pt idx="2">
                    <c:v>0.27913557040740378</c:v>
                  </c:pt>
                  <c:pt idx="3">
                    <c:v>0.34179367558026397</c:v>
                  </c:pt>
                  <c:pt idx="4">
                    <c:v>0.49916597106239391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D$20:$H$20</c:f>
              <c:numCache>
                <c:formatCode>General</c:formatCode>
                <c:ptCount val="5"/>
                <c:pt idx="0">
                  <c:v>6.05</c:v>
                </c:pt>
                <c:pt idx="1">
                  <c:v>6.0625</c:v>
                </c:pt>
                <c:pt idx="2">
                  <c:v>5.6000000000000005</c:v>
                </c:pt>
                <c:pt idx="3">
                  <c:v>6.3125</c:v>
                </c:pt>
                <c:pt idx="4">
                  <c:v>6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F4F-4C99-8F7B-5F9332E1CC61}"/>
            </c:ext>
          </c:extLst>
        </c:ser>
        <c:ser>
          <c:idx val="1"/>
          <c:order val="1"/>
          <c:tx>
            <c:strRef>
              <c:f>'For paper (average) (2)'!$I$4</c:f>
              <c:strCache>
                <c:ptCount val="1"/>
                <c:pt idx="0">
                  <c:v>G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20:$AB$20</c:f>
                <c:numCache>
                  <c:formatCode>General</c:formatCode>
                  <c:ptCount val="5"/>
                  <c:pt idx="0">
                    <c:v>0.9289330797569143</c:v>
                  </c:pt>
                  <c:pt idx="1">
                    <c:v>0.50389110926865932</c:v>
                  </c:pt>
                  <c:pt idx="2">
                    <c:v>0.27913557040740378</c:v>
                  </c:pt>
                  <c:pt idx="3">
                    <c:v>0.34179367558026397</c:v>
                  </c:pt>
                  <c:pt idx="4">
                    <c:v>0.49916597106239391</c:v>
                  </c:pt>
                </c:numCache>
              </c:numRef>
            </c:plus>
            <c:minus>
              <c:numRef>
                <c:f>'For paper (average) (2)'!$X$20:$AB$20</c:f>
                <c:numCache>
                  <c:formatCode>General</c:formatCode>
                  <c:ptCount val="5"/>
                  <c:pt idx="0">
                    <c:v>0.9289330797569143</c:v>
                  </c:pt>
                  <c:pt idx="1">
                    <c:v>0.50389110926865932</c:v>
                  </c:pt>
                  <c:pt idx="2">
                    <c:v>0.27913557040740378</c:v>
                  </c:pt>
                  <c:pt idx="3">
                    <c:v>0.34179367558026397</c:v>
                  </c:pt>
                  <c:pt idx="4">
                    <c:v>0.49916597106239391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I$20:$M$20</c:f>
              <c:numCache>
                <c:formatCode>General</c:formatCode>
                <c:ptCount val="5"/>
                <c:pt idx="0">
                  <c:v>7.01</c:v>
                </c:pt>
                <c:pt idx="1">
                  <c:v>2.41</c:v>
                </c:pt>
                <c:pt idx="2">
                  <c:v>2.36</c:v>
                </c:pt>
                <c:pt idx="3">
                  <c:v>3.3200000000000003</c:v>
                </c:pt>
                <c:pt idx="4">
                  <c:v>3.1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F4F-4C99-8F7B-5F9332E1CC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3069568"/>
        <c:axId val="133070144"/>
      </c:scatterChart>
      <c:valAx>
        <c:axId val="133069568"/>
        <c:scaling>
          <c:orientation val="minMax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/>
                  <a:t>Day</a:t>
                </a:r>
              </a:p>
            </c:rich>
          </c:tx>
          <c:layout>
            <c:manualLayout>
              <c:xMode val="edge"/>
              <c:yMode val="edge"/>
              <c:x val="0.86548289166281622"/>
              <c:y val="0.9194267121446029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33070144"/>
        <c:crosses val="autoZero"/>
        <c:crossBetween val="midCat"/>
        <c:majorUnit val="20"/>
      </c:valAx>
      <c:valAx>
        <c:axId val="133070144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VA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33069568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  <c:userShapes r:id="rId2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>
                <a:solidFill>
                  <a:schemeClr val="tx1"/>
                </a:solidFill>
              </a:defRPr>
            </a:pPr>
            <a:r>
              <a:rPr lang="en-US" sz="1200" dirty="0">
                <a:solidFill>
                  <a:schemeClr val="tx1"/>
                </a:solidFill>
              </a:rPr>
              <a:t>A) During moving to stock</a:t>
            </a:r>
          </a:p>
        </c:rich>
      </c:tx>
      <c:layout>
        <c:manualLayout>
          <c:xMode val="edge"/>
          <c:yMode val="edge"/>
          <c:x val="0.23629909336393151"/>
          <c:y val="1.2976224899434258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9447997703544875"/>
          <c:y val="0.1304614358329822"/>
          <c:w val="0.71878064374960282"/>
          <c:h val="0.64416790213269881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aper (average) (2)'!$D$4</c:f>
              <c:strCache>
                <c:ptCount val="1"/>
                <c:pt idx="0">
                  <c:v>C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21:$AB$21</c:f>
                <c:numCache>
                  <c:formatCode>General</c:formatCode>
                  <c:ptCount val="5"/>
                  <c:pt idx="0">
                    <c:v>0.61237243569579447</c:v>
                  </c:pt>
                  <c:pt idx="1">
                    <c:v>0.5543389456520863</c:v>
                  </c:pt>
                  <c:pt idx="2">
                    <c:v>0.625</c:v>
                  </c:pt>
                  <c:pt idx="3">
                    <c:v>0.52041649986653316</c:v>
                  </c:pt>
                  <c:pt idx="4">
                    <c:v>0.71807033081725358</c:v>
                  </c:pt>
                </c:numCache>
              </c:numRef>
            </c:plus>
            <c:minus>
              <c:numRef>
                <c:f>'For paper (average) (2)'!$X$20:$AB$20</c:f>
                <c:numCache>
                  <c:formatCode>General</c:formatCode>
                  <c:ptCount val="5"/>
                  <c:pt idx="0">
                    <c:v>0.9289330797569143</c:v>
                  </c:pt>
                  <c:pt idx="1">
                    <c:v>0.50389110926865932</c:v>
                  </c:pt>
                  <c:pt idx="2">
                    <c:v>0.27913557040740378</c:v>
                  </c:pt>
                  <c:pt idx="3">
                    <c:v>0.34179367558026397</c:v>
                  </c:pt>
                  <c:pt idx="4">
                    <c:v>0.49916597106239391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D$21:$H$21</c:f>
              <c:numCache>
                <c:formatCode>General</c:formatCode>
                <c:ptCount val="5"/>
                <c:pt idx="0">
                  <c:v>3.5</c:v>
                </c:pt>
                <c:pt idx="1">
                  <c:v>3.625</c:v>
                </c:pt>
                <c:pt idx="2">
                  <c:v>3.375</c:v>
                </c:pt>
                <c:pt idx="3">
                  <c:v>3.75</c:v>
                </c:pt>
                <c:pt idx="4">
                  <c:v>3.1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A77-478D-B6B5-F5CD10B6F2F1}"/>
            </c:ext>
          </c:extLst>
        </c:ser>
        <c:ser>
          <c:idx val="1"/>
          <c:order val="1"/>
          <c:tx>
            <c:strRef>
              <c:f>'For paper (average) (2)'!$I$4</c:f>
              <c:strCache>
                <c:ptCount val="1"/>
                <c:pt idx="0">
                  <c:v>G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AC$20:$AG$20</c:f>
                <c:numCache>
                  <c:formatCode>General</c:formatCode>
                  <c:ptCount val="5"/>
                  <c:pt idx="0">
                    <c:v>0.29807717121577759</c:v>
                  </c:pt>
                  <c:pt idx="1">
                    <c:v>0.3883941297187688</c:v>
                  </c:pt>
                  <c:pt idx="2">
                    <c:v>0.30797727188869028</c:v>
                  </c:pt>
                  <c:pt idx="3">
                    <c:v>0.97590983190046765</c:v>
                  </c:pt>
                  <c:pt idx="4">
                    <c:v>0.59552497848537012</c:v>
                  </c:pt>
                </c:numCache>
              </c:numRef>
            </c:plus>
            <c:minus>
              <c:numRef>
                <c:f>'For paper (average) (2)'!$AC$20:$AG$20</c:f>
                <c:numCache>
                  <c:formatCode>General</c:formatCode>
                  <c:ptCount val="5"/>
                  <c:pt idx="0">
                    <c:v>0.29807717121577759</c:v>
                  </c:pt>
                  <c:pt idx="1">
                    <c:v>0.3883941297187688</c:v>
                  </c:pt>
                  <c:pt idx="2">
                    <c:v>0.30797727188869028</c:v>
                  </c:pt>
                  <c:pt idx="3">
                    <c:v>0.97590983190046765</c:v>
                  </c:pt>
                  <c:pt idx="4">
                    <c:v>0.5955249784853701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I$21:$M$21</c:f>
              <c:numCache>
                <c:formatCode>General</c:formatCode>
                <c:ptCount val="5"/>
                <c:pt idx="0">
                  <c:v>2.6</c:v>
                </c:pt>
                <c:pt idx="1">
                  <c:v>3.6</c:v>
                </c:pt>
                <c:pt idx="2">
                  <c:v>3.5</c:v>
                </c:pt>
                <c:pt idx="3">
                  <c:v>4.5999999999999996</c:v>
                </c:pt>
                <c:pt idx="4">
                  <c:v>4.0999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A77-478D-B6B5-F5CD10B6F2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3451712"/>
        <c:axId val="133452288"/>
      </c:scatterChart>
      <c:valAx>
        <c:axId val="133451712"/>
        <c:scaling>
          <c:orientation val="minMax"/>
          <c:max val="10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133452288"/>
        <c:crosses val="autoZero"/>
        <c:crossBetween val="midCat"/>
        <c:majorUnit val="20"/>
      </c:valAx>
      <c:valAx>
        <c:axId val="133452288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Score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33451712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  <c:userShapes r:id="rId2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E) Overall movement</a:t>
            </a:r>
          </a:p>
        </c:rich>
      </c:tx>
      <c:layout>
        <c:manualLayout>
          <c:xMode val="edge"/>
          <c:yMode val="edge"/>
          <c:x val="0.26437745516955891"/>
          <c:y val="7.4208443271767798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9465774448492681"/>
          <c:y val="0.1304614358329822"/>
          <c:w val="0.71888707970019428"/>
          <c:h val="0.64234458927182947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aper (average) (2)'!$D$4</c:f>
              <c:strCache>
                <c:ptCount val="1"/>
                <c:pt idx="0">
                  <c:v>C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21:$AB$21</c:f>
                <c:numCache>
                  <c:formatCode>General</c:formatCode>
                  <c:ptCount val="5"/>
                  <c:pt idx="0">
                    <c:v>0.61237243569579447</c:v>
                  </c:pt>
                  <c:pt idx="1">
                    <c:v>0.5543389456520863</c:v>
                  </c:pt>
                  <c:pt idx="2">
                    <c:v>0.625</c:v>
                  </c:pt>
                  <c:pt idx="3">
                    <c:v>0.52041649986653316</c:v>
                  </c:pt>
                  <c:pt idx="4">
                    <c:v>0.71807033081725358</c:v>
                  </c:pt>
                </c:numCache>
              </c:numRef>
            </c:plus>
            <c:minus>
              <c:numRef>
                <c:f>'For paper (average) (2)'!$X$21:$AB$21</c:f>
                <c:numCache>
                  <c:formatCode>General</c:formatCode>
                  <c:ptCount val="5"/>
                  <c:pt idx="0">
                    <c:v>0.61237243569579447</c:v>
                  </c:pt>
                  <c:pt idx="1">
                    <c:v>0.5543389456520863</c:v>
                  </c:pt>
                  <c:pt idx="2">
                    <c:v>0.625</c:v>
                  </c:pt>
                  <c:pt idx="3">
                    <c:v>0.52041649986653316</c:v>
                  </c:pt>
                  <c:pt idx="4">
                    <c:v>0.71807033081725358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D$22:$H$22</c:f>
              <c:numCache>
                <c:formatCode>General</c:formatCode>
                <c:ptCount val="5"/>
                <c:pt idx="0">
                  <c:v>4.75</c:v>
                </c:pt>
                <c:pt idx="1">
                  <c:v>3.8499999999999996</c:v>
                </c:pt>
                <c:pt idx="2">
                  <c:v>3.1875</c:v>
                </c:pt>
                <c:pt idx="3">
                  <c:v>3.7249999999999996</c:v>
                </c:pt>
                <c:pt idx="4">
                  <c:v>4.4874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B96-4014-A696-336B4E7DC345}"/>
            </c:ext>
          </c:extLst>
        </c:ser>
        <c:ser>
          <c:idx val="1"/>
          <c:order val="1"/>
          <c:tx>
            <c:strRef>
              <c:f>'For paper (average) (2)'!$I$4</c:f>
              <c:strCache>
                <c:ptCount val="1"/>
                <c:pt idx="0">
                  <c:v>G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AC$21:$AG$21</c:f>
                <c:numCache>
                  <c:formatCode>General</c:formatCode>
                  <c:ptCount val="5"/>
                  <c:pt idx="0">
                    <c:v>9.9999999999999978E-2</c:v>
                  </c:pt>
                  <c:pt idx="1">
                    <c:v>0.29154759474226527</c:v>
                  </c:pt>
                  <c:pt idx="2">
                    <c:v>0.27386127875258304</c:v>
                  </c:pt>
                  <c:pt idx="3">
                    <c:v>0.24494897427831808</c:v>
                  </c:pt>
                  <c:pt idx="4">
                    <c:v>0.45825756949558411</c:v>
                  </c:pt>
                </c:numCache>
              </c:numRef>
            </c:plus>
            <c:minus>
              <c:numRef>
                <c:f>'For paper (average) (2)'!$AC$21:$AG$21</c:f>
                <c:numCache>
                  <c:formatCode>General</c:formatCode>
                  <c:ptCount val="5"/>
                  <c:pt idx="0">
                    <c:v>9.9999999999999978E-2</c:v>
                  </c:pt>
                  <c:pt idx="1">
                    <c:v>0.29154759474226527</c:v>
                  </c:pt>
                  <c:pt idx="2">
                    <c:v>0.27386127875258304</c:v>
                  </c:pt>
                  <c:pt idx="3">
                    <c:v>0.24494897427831808</c:v>
                  </c:pt>
                  <c:pt idx="4">
                    <c:v>0.45825756949558411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I$22:$M$22</c:f>
              <c:numCache>
                <c:formatCode>General</c:formatCode>
                <c:ptCount val="5"/>
                <c:pt idx="0">
                  <c:v>5.6099999999999994</c:v>
                </c:pt>
                <c:pt idx="1">
                  <c:v>2.4699999999999998</c:v>
                </c:pt>
                <c:pt idx="2">
                  <c:v>1.1600000000000001</c:v>
                </c:pt>
                <c:pt idx="3">
                  <c:v>3.3600000000000003</c:v>
                </c:pt>
                <c:pt idx="4">
                  <c:v>2.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B96-4014-A696-336B4E7DC3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3454016"/>
        <c:axId val="133454592"/>
      </c:scatterChart>
      <c:valAx>
        <c:axId val="133454016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133454592"/>
        <c:crosses val="autoZero"/>
        <c:crossBetween val="midCat"/>
        <c:majorUnit val="20"/>
      </c:valAx>
      <c:valAx>
        <c:axId val="133454592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VA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33454016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  <c:userShapes r:id="rId2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B) Head movement </a:t>
            </a:r>
          </a:p>
        </c:rich>
      </c:tx>
      <c:layout>
        <c:manualLayout>
          <c:xMode val="edge"/>
          <c:yMode val="edge"/>
          <c:x val="0.25295288091105372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906300450888319"/>
          <c:y val="0.11935114744231294"/>
          <c:w val="0.7241976162761683"/>
          <c:h val="0.65254351462385307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aper (average) (2)'!$D$4</c:f>
              <c:strCache>
                <c:ptCount val="1"/>
                <c:pt idx="0">
                  <c:v>C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23:$AB$23</c:f>
                <c:numCache>
                  <c:formatCode>General</c:formatCode>
                  <c:ptCount val="5"/>
                  <c:pt idx="0">
                    <c:v>0.77969010938107053</c:v>
                  </c:pt>
                  <c:pt idx="1">
                    <c:v>0.84072761145728003</c:v>
                  </c:pt>
                  <c:pt idx="2">
                    <c:v>0.83625529395434417</c:v>
                  </c:pt>
                  <c:pt idx="3">
                    <c:v>0.68328251843582111</c:v>
                  </c:pt>
                  <c:pt idx="4">
                    <c:v>0.56064508975524452</c:v>
                  </c:pt>
                </c:numCache>
              </c:numRef>
            </c:plus>
            <c:minus>
              <c:numRef>
                <c:f>'For paper (average) (2)'!$X$23:$AB$23</c:f>
                <c:numCache>
                  <c:formatCode>General</c:formatCode>
                  <c:ptCount val="5"/>
                  <c:pt idx="0">
                    <c:v>0.77969010938107053</c:v>
                  </c:pt>
                  <c:pt idx="1">
                    <c:v>0.84072761145728003</c:v>
                  </c:pt>
                  <c:pt idx="2">
                    <c:v>0.83625529395434417</c:v>
                  </c:pt>
                  <c:pt idx="3">
                    <c:v>0.68328251843582111</c:v>
                  </c:pt>
                  <c:pt idx="4">
                    <c:v>0.5606450897552445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D$23:$H$23</c:f>
              <c:numCache>
                <c:formatCode>General</c:formatCode>
                <c:ptCount val="5"/>
                <c:pt idx="0">
                  <c:v>5.9</c:v>
                </c:pt>
                <c:pt idx="1">
                  <c:v>5.6125000000000007</c:v>
                </c:pt>
                <c:pt idx="2">
                  <c:v>4.9375</c:v>
                </c:pt>
                <c:pt idx="3">
                  <c:v>5.0250000000000004</c:v>
                </c:pt>
                <c:pt idx="4">
                  <c:v>4.6375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75D-4304-BFAC-FBFD69CD7F48}"/>
            </c:ext>
          </c:extLst>
        </c:ser>
        <c:ser>
          <c:idx val="1"/>
          <c:order val="1"/>
          <c:tx>
            <c:strRef>
              <c:f>'For paper (average) (2)'!$I$4</c:f>
              <c:strCache>
                <c:ptCount val="1"/>
                <c:pt idx="0">
                  <c:v>G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AC$22:$AG$22</c:f>
                <c:numCache>
                  <c:formatCode>General</c:formatCode>
                  <c:ptCount val="5"/>
                  <c:pt idx="0">
                    <c:v>0.2456623699307649</c:v>
                  </c:pt>
                  <c:pt idx="1">
                    <c:v>0.32503845926290037</c:v>
                  </c:pt>
                  <c:pt idx="2">
                    <c:v>0.13729530217745958</c:v>
                  </c:pt>
                  <c:pt idx="3">
                    <c:v>0.40292679235811513</c:v>
                  </c:pt>
                  <c:pt idx="4">
                    <c:v>0.33926390907374798</c:v>
                  </c:pt>
                </c:numCache>
              </c:numRef>
            </c:plus>
            <c:minus>
              <c:numRef>
                <c:f>'For paper (average) (2)'!$AC$22:$AG$22</c:f>
                <c:numCache>
                  <c:formatCode>General</c:formatCode>
                  <c:ptCount val="5"/>
                  <c:pt idx="0">
                    <c:v>0.2456623699307649</c:v>
                  </c:pt>
                  <c:pt idx="1">
                    <c:v>0.32503845926290037</c:v>
                  </c:pt>
                  <c:pt idx="2">
                    <c:v>0.13729530217745958</c:v>
                  </c:pt>
                  <c:pt idx="3">
                    <c:v>0.40292679235811513</c:v>
                  </c:pt>
                  <c:pt idx="4">
                    <c:v>0.33926390907374798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I$23:$M$23</c:f>
              <c:numCache>
                <c:formatCode>General</c:formatCode>
                <c:ptCount val="5"/>
                <c:pt idx="0">
                  <c:v>6.6099999999999994</c:v>
                </c:pt>
                <c:pt idx="1">
                  <c:v>3.2600000000000002</c:v>
                </c:pt>
                <c:pt idx="2">
                  <c:v>2.0599999999999996</c:v>
                </c:pt>
                <c:pt idx="3">
                  <c:v>3.91</c:v>
                </c:pt>
                <c:pt idx="4">
                  <c:v>3.5799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75D-4304-BFAC-FBFD69CD7F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8097344"/>
        <c:axId val="88097920"/>
      </c:scatterChart>
      <c:valAx>
        <c:axId val="88097344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88097920"/>
        <c:crosses val="autoZero"/>
        <c:crossBetween val="midCat"/>
        <c:majorUnit val="20"/>
      </c:valAx>
      <c:valAx>
        <c:axId val="88097920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VA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88097344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  <c:userShapes r:id="rId2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C) Tail flicking</a:t>
            </a:r>
          </a:p>
        </c:rich>
      </c:tx>
      <c:layout>
        <c:manualLayout>
          <c:xMode val="edge"/>
          <c:yMode val="edge"/>
          <c:x val="0.27008019998472044"/>
          <c:y val="8.9141951307209685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385929708059298"/>
          <c:y val="0.1304614358329822"/>
          <c:w val="0.72968552710452816"/>
          <c:h val="0.6450799953203874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aper (average) (2)'!$D$4</c:f>
              <c:strCache>
                <c:ptCount val="1"/>
                <c:pt idx="0">
                  <c:v>C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24:$AB$24</c:f>
                <c:numCache>
                  <c:formatCode>General</c:formatCode>
                  <c:ptCount val="5"/>
                  <c:pt idx="0">
                    <c:v>1.2892989050901527</c:v>
                  </c:pt>
                  <c:pt idx="1">
                    <c:v>1.3418542829482889</c:v>
                  </c:pt>
                  <c:pt idx="2">
                    <c:v>0.930613596863202</c:v>
                  </c:pt>
                  <c:pt idx="3">
                    <c:v>0.2557668208870465</c:v>
                  </c:pt>
                  <c:pt idx="4">
                    <c:v>0.56876144677125806</c:v>
                  </c:pt>
                </c:numCache>
              </c:numRef>
            </c:plus>
            <c:minus>
              <c:numRef>
                <c:f>'For paper (average) (2)'!$X$24:$AB$24</c:f>
                <c:numCache>
                  <c:formatCode>General</c:formatCode>
                  <c:ptCount val="5"/>
                  <c:pt idx="0">
                    <c:v>1.2892989050901527</c:v>
                  </c:pt>
                  <c:pt idx="1">
                    <c:v>1.3418542829482889</c:v>
                  </c:pt>
                  <c:pt idx="2">
                    <c:v>0.930613596863202</c:v>
                  </c:pt>
                  <c:pt idx="3">
                    <c:v>0.2557668208870465</c:v>
                  </c:pt>
                  <c:pt idx="4">
                    <c:v>0.5687614467712580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D$24:$H$24</c:f>
              <c:numCache>
                <c:formatCode>General</c:formatCode>
                <c:ptCount val="5"/>
                <c:pt idx="0">
                  <c:v>2.5750000000000002</c:v>
                </c:pt>
                <c:pt idx="1">
                  <c:v>2.6625000000000001</c:v>
                </c:pt>
                <c:pt idx="2">
                  <c:v>2.8250000000000002</c:v>
                </c:pt>
                <c:pt idx="3">
                  <c:v>1.4500000000000002</c:v>
                </c:pt>
                <c:pt idx="4">
                  <c:v>3.58749999999999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5B7-4870-9211-E6E8B4365D77}"/>
            </c:ext>
          </c:extLst>
        </c:ser>
        <c:ser>
          <c:idx val="1"/>
          <c:order val="1"/>
          <c:tx>
            <c:strRef>
              <c:f>'For paper (average) (2)'!$I$4</c:f>
              <c:strCache>
                <c:ptCount val="1"/>
                <c:pt idx="0">
                  <c:v>G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AC$24:$AG$24</c:f>
                <c:numCache>
                  <c:formatCode>General</c:formatCode>
                  <c:ptCount val="5"/>
                  <c:pt idx="0">
                    <c:v>0.30716445106815338</c:v>
                  </c:pt>
                  <c:pt idx="1">
                    <c:v>0.307001628660175</c:v>
                  </c:pt>
                  <c:pt idx="2">
                    <c:v>0.16852299546352731</c:v>
                  </c:pt>
                  <c:pt idx="3">
                    <c:v>0.65696270822627356</c:v>
                  </c:pt>
                  <c:pt idx="4">
                    <c:v>0.53127205836557956</c:v>
                  </c:pt>
                </c:numCache>
              </c:numRef>
            </c:plus>
            <c:minus>
              <c:numRef>
                <c:f>'For paper (average) (2)'!$AC$24:$AG$24</c:f>
                <c:numCache>
                  <c:formatCode>General</c:formatCode>
                  <c:ptCount val="5"/>
                  <c:pt idx="0">
                    <c:v>0.30716445106815338</c:v>
                  </c:pt>
                  <c:pt idx="1">
                    <c:v>0.307001628660175</c:v>
                  </c:pt>
                  <c:pt idx="2">
                    <c:v>0.16852299546352731</c:v>
                  </c:pt>
                  <c:pt idx="3">
                    <c:v>0.65696270822627356</c:v>
                  </c:pt>
                  <c:pt idx="4">
                    <c:v>0.5312720583655795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I$24:$M$24</c:f>
              <c:numCache>
                <c:formatCode>General</c:formatCode>
                <c:ptCount val="5"/>
                <c:pt idx="0">
                  <c:v>3.04</c:v>
                </c:pt>
                <c:pt idx="1">
                  <c:v>0.85</c:v>
                </c:pt>
                <c:pt idx="2">
                  <c:v>0.86999999999999988</c:v>
                </c:pt>
                <c:pt idx="3">
                  <c:v>2.16</c:v>
                </c:pt>
                <c:pt idx="4">
                  <c:v>3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5B7-4870-9211-E6E8B4365D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8099648"/>
        <c:axId val="88100224"/>
      </c:scatterChart>
      <c:valAx>
        <c:axId val="88099648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88100224"/>
        <c:crosses val="autoZero"/>
        <c:crossBetween val="midCat"/>
        <c:majorUnit val="20"/>
      </c:valAx>
      <c:valAx>
        <c:axId val="88100224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VA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88099648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  <c:userShapes r:id="rId2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D) Walking / Stepping</a:t>
            </a:r>
          </a:p>
        </c:rich>
      </c:tx>
      <c:layout>
        <c:manualLayout>
          <c:xMode val="edge"/>
          <c:yMode val="edge"/>
          <c:x val="0.2340438736298972"/>
          <c:y val="9.3149600852816001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906300450888319"/>
          <c:y val="0.1304614358329822"/>
          <c:w val="0.7241976162761683"/>
          <c:h val="0.64622325795242785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aper (average) (2)'!$D$4</c:f>
              <c:strCache>
                <c:ptCount val="1"/>
                <c:pt idx="0">
                  <c:v>C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25:$AB$25</c:f>
                <c:numCache>
                  <c:formatCode>General</c:formatCode>
                  <c:ptCount val="5"/>
                  <c:pt idx="0">
                    <c:v>1.1317390747576639</c:v>
                  </c:pt>
                  <c:pt idx="1">
                    <c:v>1.356926674511191</c:v>
                  </c:pt>
                  <c:pt idx="2">
                    <c:v>0.79592058858489978</c:v>
                  </c:pt>
                  <c:pt idx="3">
                    <c:v>0.48175028109315449</c:v>
                  </c:pt>
                  <c:pt idx="4">
                    <c:v>0.97841283038739124</c:v>
                  </c:pt>
                </c:numCache>
              </c:numRef>
            </c:plus>
            <c:minus>
              <c:numRef>
                <c:f>'For paper (average) (2)'!$X$25:$AB$25</c:f>
                <c:numCache>
                  <c:formatCode>General</c:formatCode>
                  <c:ptCount val="5"/>
                  <c:pt idx="0">
                    <c:v>1.1317390747576639</c:v>
                  </c:pt>
                  <c:pt idx="1">
                    <c:v>1.356926674511191</c:v>
                  </c:pt>
                  <c:pt idx="2">
                    <c:v>0.79592058858489978</c:v>
                  </c:pt>
                  <c:pt idx="3">
                    <c:v>0.48175028109315449</c:v>
                  </c:pt>
                  <c:pt idx="4">
                    <c:v>0.9784128303873912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D$25:$H$25</c:f>
              <c:numCache>
                <c:formatCode>General</c:formatCode>
                <c:ptCount val="5"/>
                <c:pt idx="0">
                  <c:v>2.9000000000000004</c:v>
                </c:pt>
                <c:pt idx="1">
                  <c:v>2.35</c:v>
                </c:pt>
                <c:pt idx="2">
                  <c:v>3.0125000000000002</c:v>
                </c:pt>
                <c:pt idx="3">
                  <c:v>2.0499999999999998</c:v>
                </c:pt>
                <c:pt idx="4">
                  <c:v>2.4249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C06-44CB-BF49-4598A01DD136}"/>
            </c:ext>
          </c:extLst>
        </c:ser>
        <c:ser>
          <c:idx val="1"/>
          <c:order val="1"/>
          <c:tx>
            <c:strRef>
              <c:f>'For paper (average) (2)'!$I$4</c:f>
              <c:strCache>
                <c:ptCount val="1"/>
                <c:pt idx="0">
                  <c:v>G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AC$25:$AG$25</c:f>
                <c:numCache>
                  <c:formatCode>General</c:formatCode>
                  <c:ptCount val="5"/>
                  <c:pt idx="0">
                    <c:v>0.34387497728098859</c:v>
                  </c:pt>
                  <c:pt idx="1">
                    <c:v>0.219431082574917</c:v>
                  </c:pt>
                  <c:pt idx="2">
                    <c:v>0.16170961628796227</c:v>
                  </c:pt>
                  <c:pt idx="3">
                    <c:v>0.84876380695691778</c:v>
                  </c:pt>
                  <c:pt idx="4">
                    <c:v>0.61441028637222539</c:v>
                  </c:pt>
                </c:numCache>
              </c:numRef>
            </c:plus>
            <c:minus>
              <c:numRef>
                <c:f>'For paper (average) (2)'!$AC$25:$AG$25</c:f>
                <c:numCache>
                  <c:formatCode>General</c:formatCode>
                  <c:ptCount val="5"/>
                  <c:pt idx="0">
                    <c:v>0.34387497728098859</c:v>
                  </c:pt>
                  <c:pt idx="1">
                    <c:v>0.219431082574917</c:v>
                  </c:pt>
                  <c:pt idx="2">
                    <c:v>0.16170961628796227</c:v>
                  </c:pt>
                  <c:pt idx="3">
                    <c:v>0.84876380695691778</c:v>
                  </c:pt>
                  <c:pt idx="4">
                    <c:v>0.61441028637222539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I$25:$M$25</c:f>
              <c:numCache>
                <c:formatCode>General</c:formatCode>
                <c:ptCount val="5"/>
                <c:pt idx="0">
                  <c:v>5.5</c:v>
                </c:pt>
                <c:pt idx="1">
                  <c:v>2.37</c:v>
                </c:pt>
                <c:pt idx="2">
                  <c:v>0.52</c:v>
                </c:pt>
                <c:pt idx="3">
                  <c:v>2.23</c:v>
                </c:pt>
                <c:pt idx="4">
                  <c:v>1.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C06-44CB-BF49-4598A01DD1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8101952"/>
        <c:axId val="88102528"/>
      </c:scatterChart>
      <c:valAx>
        <c:axId val="88101952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88102528"/>
        <c:crosses val="autoZero"/>
        <c:crossBetween val="midCat"/>
        <c:majorUnit val="20"/>
      </c:valAx>
      <c:valAx>
        <c:axId val="88102528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VA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88101952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  <c:userShapes r:id="rId2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F) During blood sampling</a:t>
            </a:r>
          </a:p>
        </c:rich>
      </c:tx>
      <c:layout>
        <c:manualLayout>
          <c:xMode val="edge"/>
          <c:yMode val="edge"/>
          <c:x val="0.27284933038070058"/>
          <c:y val="8.6817564103607221E-4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376540521347293"/>
          <c:y val="0.1304614358329822"/>
          <c:w val="0.72965460220308331"/>
          <c:h val="0.63794888800279936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aper (average) (2)'!$D$4</c:f>
              <c:strCache>
                <c:ptCount val="1"/>
                <c:pt idx="0">
                  <c:v>C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29:$AB$29</c:f>
                <c:numCache>
                  <c:formatCode>General</c:formatCode>
                  <c:ptCount val="5"/>
                  <c:pt idx="0">
                    <c:v>0.4732423621500228</c:v>
                  </c:pt>
                  <c:pt idx="1">
                    <c:v>0.42695628191498325</c:v>
                  </c:pt>
                  <c:pt idx="2">
                    <c:v>0.35355339059327379</c:v>
                  </c:pt>
                  <c:pt idx="3">
                    <c:v>0.45643546458763845</c:v>
                  </c:pt>
                  <c:pt idx="4">
                    <c:v>0.5</c:v>
                  </c:pt>
                </c:numCache>
              </c:numRef>
            </c:plus>
            <c:minus>
              <c:numRef>
                <c:f>'For paper (average) (2)'!$X$29:$AB$29</c:f>
                <c:numCache>
                  <c:formatCode>General</c:formatCode>
                  <c:ptCount val="5"/>
                  <c:pt idx="0">
                    <c:v>0.4732423621500228</c:v>
                  </c:pt>
                  <c:pt idx="1">
                    <c:v>0.42695628191498325</c:v>
                  </c:pt>
                  <c:pt idx="2">
                    <c:v>0.35355339059327379</c:v>
                  </c:pt>
                  <c:pt idx="3">
                    <c:v>0.45643546458763845</c:v>
                  </c:pt>
                  <c:pt idx="4">
                    <c:v>0.5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D$29:$H$29</c:f>
              <c:numCache>
                <c:formatCode>General</c:formatCode>
                <c:ptCount val="5"/>
                <c:pt idx="0">
                  <c:v>3.875</c:v>
                </c:pt>
                <c:pt idx="1">
                  <c:v>3.875</c:v>
                </c:pt>
                <c:pt idx="2">
                  <c:v>4</c:v>
                </c:pt>
                <c:pt idx="3">
                  <c:v>4</c:v>
                </c:pt>
                <c:pt idx="4">
                  <c:v>4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C4A-4B3F-AE7F-76472C019C98}"/>
            </c:ext>
          </c:extLst>
        </c:ser>
        <c:ser>
          <c:idx val="1"/>
          <c:order val="1"/>
          <c:tx>
            <c:strRef>
              <c:f>'For paper (average) (2)'!$I$4</c:f>
              <c:strCache>
                <c:ptCount val="1"/>
                <c:pt idx="0">
                  <c:v>G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AC$29:$AG$29</c:f>
                <c:numCache>
                  <c:formatCode>General</c:formatCode>
                  <c:ptCount val="5"/>
                  <c:pt idx="0">
                    <c:v>0.29999999999999977</c:v>
                  </c:pt>
                  <c:pt idx="1">
                    <c:v>0.29154759474226527</c:v>
                  </c:pt>
                  <c:pt idx="2">
                    <c:v>0.22360679774997896</c:v>
                  </c:pt>
                  <c:pt idx="3">
                    <c:v>0.22360679774997896</c:v>
                  </c:pt>
                  <c:pt idx="4">
                    <c:v>0.27386127875258304</c:v>
                  </c:pt>
                </c:numCache>
              </c:numRef>
            </c:plus>
            <c:minus>
              <c:numRef>
                <c:f>'For paper (average) (2)'!$AC$29:$AG$29</c:f>
                <c:numCache>
                  <c:formatCode>General</c:formatCode>
                  <c:ptCount val="5"/>
                  <c:pt idx="0">
                    <c:v>0.29999999999999977</c:v>
                  </c:pt>
                  <c:pt idx="1">
                    <c:v>0.29154759474226527</c:v>
                  </c:pt>
                  <c:pt idx="2">
                    <c:v>0.22360679774997896</c:v>
                  </c:pt>
                  <c:pt idx="3">
                    <c:v>0.22360679774997896</c:v>
                  </c:pt>
                  <c:pt idx="4">
                    <c:v>0.2738612787525830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I$29:$M$29</c:f>
              <c:numCache>
                <c:formatCode>General</c:formatCode>
                <c:ptCount val="5"/>
                <c:pt idx="0">
                  <c:v>3.7</c:v>
                </c:pt>
                <c:pt idx="1">
                  <c:v>2.9</c:v>
                </c:pt>
                <c:pt idx="2">
                  <c:v>2.5</c:v>
                </c:pt>
                <c:pt idx="3">
                  <c:v>3</c:v>
                </c:pt>
                <c:pt idx="4">
                  <c:v>2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C4A-4B3F-AE7F-76472C019C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3490368"/>
        <c:axId val="133490944"/>
      </c:scatterChart>
      <c:valAx>
        <c:axId val="133490368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133490944"/>
        <c:crosses val="autoZero"/>
        <c:crossBetween val="midCat"/>
        <c:majorUnit val="20"/>
      </c:valAx>
      <c:valAx>
        <c:axId val="133490944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Score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33490368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D) Walking/Stepping</a:t>
            </a:r>
            <a:endParaRPr lang="ja-JP" sz="1200" dirty="0"/>
          </a:p>
        </c:rich>
      </c:tx>
      <c:overlay val="0"/>
    </c:title>
    <c:autoTitleDeleted val="0"/>
    <c:plotArea>
      <c:layout>
        <c:manualLayout>
          <c:layoutTarget val="inner"/>
          <c:xMode val="edge"/>
          <c:yMode val="edge"/>
          <c:x val="0.17294587828986341"/>
          <c:y val="0.1304614358329822"/>
          <c:w val="0.74587027801950623"/>
          <c:h val="0.6980031991276773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aper (average) (2)'!$D$4</c:f>
              <c:strCache>
                <c:ptCount val="1"/>
                <c:pt idx="0">
                  <c:v>C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9:$AB$9</c:f>
                <c:numCache>
                  <c:formatCode>General</c:formatCode>
                  <c:ptCount val="5"/>
                  <c:pt idx="0">
                    <c:v>1.3899190623917645</c:v>
                  </c:pt>
                  <c:pt idx="1">
                    <c:v>1.3289054079705349</c:v>
                  </c:pt>
                  <c:pt idx="2">
                    <c:v>1.0280189281655598</c:v>
                  </c:pt>
                  <c:pt idx="3">
                    <c:v>0.92090874502670805</c:v>
                  </c:pt>
                  <c:pt idx="4">
                    <c:v>0.70574281198370503</c:v>
                  </c:pt>
                </c:numCache>
              </c:numRef>
            </c:plus>
            <c:minus>
              <c:numRef>
                <c:f>'For paper (average) (2)'!$X$9:$AB$9</c:f>
                <c:numCache>
                  <c:formatCode>General</c:formatCode>
                  <c:ptCount val="5"/>
                  <c:pt idx="0">
                    <c:v>1.3899190623917645</c:v>
                  </c:pt>
                  <c:pt idx="1">
                    <c:v>1.3289054079705349</c:v>
                  </c:pt>
                  <c:pt idx="2">
                    <c:v>1.0280189281655598</c:v>
                  </c:pt>
                  <c:pt idx="3">
                    <c:v>0.92090874502670805</c:v>
                  </c:pt>
                  <c:pt idx="4">
                    <c:v>0.7057428119837050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D$9:$H$9</c:f>
              <c:numCache>
                <c:formatCode>General</c:formatCode>
                <c:ptCount val="5"/>
                <c:pt idx="0">
                  <c:v>4.2249999999999996</c:v>
                </c:pt>
                <c:pt idx="1">
                  <c:v>3.7124999999999999</c:v>
                </c:pt>
                <c:pt idx="2">
                  <c:v>2.9125000000000001</c:v>
                </c:pt>
                <c:pt idx="3">
                  <c:v>3.6375000000000002</c:v>
                </c:pt>
                <c:pt idx="4">
                  <c:v>5.7625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5CF-49E3-891B-8C99156A3B5B}"/>
            </c:ext>
          </c:extLst>
        </c:ser>
        <c:ser>
          <c:idx val="1"/>
          <c:order val="1"/>
          <c:tx>
            <c:strRef>
              <c:f>'For paper (average) (2)'!$I$4</c:f>
              <c:strCache>
                <c:ptCount val="1"/>
                <c:pt idx="0">
                  <c:v>G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AC$9:$AG$9</c:f>
                <c:numCache>
                  <c:formatCode>General</c:formatCode>
                  <c:ptCount val="5"/>
                  <c:pt idx="0">
                    <c:v>0.5390732788777427</c:v>
                  </c:pt>
                  <c:pt idx="1">
                    <c:v>0.31128764832546763</c:v>
                  </c:pt>
                  <c:pt idx="2">
                    <c:v>0.3</c:v>
                  </c:pt>
                  <c:pt idx="3">
                    <c:v>1.0087863995911124</c:v>
                  </c:pt>
                  <c:pt idx="4">
                    <c:v>0.40620192023179796</c:v>
                  </c:pt>
                </c:numCache>
              </c:numRef>
            </c:plus>
            <c:minus>
              <c:numRef>
                <c:f>'For paper (average) (2)'!$AC$9:$AG$9</c:f>
                <c:numCache>
                  <c:formatCode>General</c:formatCode>
                  <c:ptCount val="5"/>
                  <c:pt idx="0">
                    <c:v>0.5390732788777427</c:v>
                  </c:pt>
                  <c:pt idx="1">
                    <c:v>0.31128764832546763</c:v>
                  </c:pt>
                  <c:pt idx="2">
                    <c:v>0.3</c:v>
                  </c:pt>
                  <c:pt idx="3">
                    <c:v>1.0087863995911124</c:v>
                  </c:pt>
                  <c:pt idx="4">
                    <c:v>0.4062019202317979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I$9:$M$9</c:f>
              <c:numCache>
                <c:formatCode>General</c:formatCode>
                <c:ptCount val="5"/>
                <c:pt idx="0">
                  <c:v>5.96</c:v>
                </c:pt>
                <c:pt idx="1">
                  <c:v>0.37</c:v>
                </c:pt>
                <c:pt idx="2">
                  <c:v>0.3</c:v>
                </c:pt>
                <c:pt idx="3">
                  <c:v>1.42</c:v>
                </c:pt>
                <c:pt idx="4">
                  <c:v>0.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5CF-49E3-891B-8C99156A3B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080832"/>
        <c:axId val="84081408"/>
      </c:scatterChart>
      <c:valAx>
        <c:axId val="84080832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84081408"/>
        <c:crosses val="autoZero"/>
        <c:crossBetween val="midCat"/>
        <c:majorUnit val="20"/>
      </c:valAx>
      <c:valAx>
        <c:axId val="84081408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VA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84080832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E) Overall</a:t>
            </a:r>
            <a:r>
              <a:rPr lang="ja-JP" altLang="en-US" sz="1200" baseline="0" dirty="0"/>
              <a:t> </a:t>
            </a:r>
            <a:r>
              <a:rPr lang="en-US" altLang="ja-JP" sz="1200" baseline="0" dirty="0"/>
              <a:t>movement</a:t>
            </a:r>
            <a:endParaRPr lang="ja-JP" sz="1200" dirty="0"/>
          </a:p>
        </c:rich>
      </c:tx>
      <c:layout>
        <c:manualLayout>
          <c:xMode val="edge"/>
          <c:yMode val="edge"/>
          <c:x val="0.26673654739083952"/>
          <c:y val="3.065005878616918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904654639689025"/>
          <c:y val="0.1304614358329822"/>
          <c:w val="0.75128263397455053"/>
          <c:h val="0.6980031991276773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aper (average) (2)'!$D$4</c:f>
              <c:strCache>
                <c:ptCount val="1"/>
                <c:pt idx="0">
                  <c:v>C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6:$AB$6</c:f>
                <c:numCache>
                  <c:formatCode>General</c:formatCode>
                  <c:ptCount val="5"/>
                  <c:pt idx="0">
                    <c:v>0.45529294598825365</c:v>
                  </c:pt>
                  <c:pt idx="1">
                    <c:v>0.92587233641217193</c:v>
                  </c:pt>
                  <c:pt idx="2">
                    <c:v>0.19512282456613489</c:v>
                  </c:pt>
                  <c:pt idx="3">
                    <c:v>0.32299058293806349</c:v>
                  </c:pt>
                  <c:pt idx="4">
                    <c:v>0.45063612445815737</c:v>
                  </c:pt>
                </c:numCache>
              </c:numRef>
            </c:plus>
            <c:minus>
              <c:numRef>
                <c:f>'For paper (average) (2)'!$X$6:$AB$6</c:f>
                <c:numCache>
                  <c:formatCode>General</c:formatCode>
                  <c:ptCount val="5"/>
                  <c:pt idx="0">
                    <c:v>0.45529294598825365</c:v>
                  </c:pt>
                  <c:pt idx="1">
                    <c:v>0.92587233641217193</c:v>
                  </c:pt>
                  <c:pt idx="2">
                    <c:v>0.19512282456613489</c:v>
                  </c:pt>
                  <c:pt idx="3">
                    <c:v>0.32299058293806349</c:v>
                  </c:pt>
                  <c:pt idx="4">
                    <c:v>0.45063612445815737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D$6:$H$6</c:f>
              <c:numCache>
                <c:formatCode>General</c:formatCode>
                <c:ptCount val="5"/>
                <c:pt idx="0">
                  <c:v>5.9250000000000007</c:v>
                </c:pt>
                <c:pt idx="1">
                  <c:v>5.4375</c:v>
                </c:pt>
                <c:pt idx="2">
                  <c:v>4.4874999999999998</c:v>
                </c:pt>
                <c:pt idx="3">
                  <c:v>5.0874999999999995</c:v>
                </c:pt>
                <c:pt idx="4">
                  <c:v>6.5374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E9F-44F0-9B00-BB4A1BEBB33E}"/>
            </c:ext>
          </c:extLst>
        </c:ser>
        <c:ser>
          <c:idx val="1"/>
          <c:order val="1"/>
          <c:tx>
            <c:strRef>
              <c:f>'For paper (average) (2)'!$I$4</c:f>
              <c:strCache>
                <c:ptCount val="1"/>
                <c:pt idx="0">
                  <c:v>G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AC$6:$AG$6</c:f>
                <c:numCache>
                  <c:formatCode>General</c:formatCode>
                  <c:ptCount val="5"/>
                  <c:pt idx="0">
                    <c:v>0.42142615011411244</c:v>
                  </c:pt>
                  <c:pt idx="1">
                    <c:v>0.28169132042006551</c:v>
                  </c:pt>
                  <c:pt idx="2">
                    <c:v>0.19646882704388535</c:v>
                  </c:pt>
                  <c:pt idx="3">
                    <c:v>0.62900715417235109</c:v>
                  </c:pt>
                  <c:pt idx="4">
                    <c:v>0.16507574019219173</c:v>
                  </c:pt>
                </c:numCache>
              </c:numRef>
            </c:plus>
            <c:minus>
              <c:numRef>
                <c:f>'For paper (average) (2)'!$AC$6:$AG$6</c:f>
                <c:numCache>
                  <c:formatCode>General</c:formatCode>
                  <c:ptCount val="5"/>
                  <c:pt idx="0">
                    <c:v>0.42142615011411244</c:v>
                  </c:pt>
                  <c:pt idx="1">
                    <c:v>0.28169132042006551</c:v>
                  </c:pt>
                  <c:pt idx="2">
                    <c:v>0.19646882704388535</c:v>
                  </c:pt>
                  <c:pt idx="3">
                    <c:v>0.62900715417235109</c:v>
                  </c:pt>
                  <c:pt idx="4">
                    <c:v>0.1650757401921917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I$6:$M$6</c:f>
              <c:numCache>
                <c:formatCode>General</c:formatCode>
                <c:ptCount val="5"/>
                <c:pt idx="0">
                  <c:v>5.1899999999999995</c:v>
                </c:pt>
                <c:pt idx="1">
                  <c:v>0.79</c:v>
                </c:pt>
                <c:pt idx="2">
                  <c:v>1.0899999999999999</c:v>
                </c:pt>
                <c:pt idx="3">
                  <c:v>1.83</c:v>
                </c:pt>
                <c:pt idx="4">
                  <c:v>1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E9F-44F0-9B00-BB4A1BEBB3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5939968"/>
        <c:axId val="95940544"/>
      </c:scatterChart>
      <c:valAx>
        <c:axId val="95939968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95940544"/>
        <c:crosses val="autoZero"/>
        <c:crossBetween val="midCat"/>
        <c:majorUnit val="20"/>
      </c:valAx>
      <c:valAx>
        <c:axId val="95940544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VA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95939968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C) Tail flicking</a:t>
            </a:r>
            <a:endParaRPr lang="ja-JP" sz="1200" dirty="0"/>
          </a:p>
        </c:rich>
      </c:tx>
      <c:layout>
        <c:manualLayout>
          <c:xMode val="edge"/>
          <c:yMode val="edge"/>
          <c:x val="0.29916174846793536"/>
          <c:y val="1.923323745741144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904654639689025"/>
          <c:y val="0.1304614358329822"/>
          <c:w val="0.75128263397455053"/>
          <c:h val="0.6980031991276773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aper (average) (2)'!$D$4</c:f>
              <c:strCache>
                <c:ptCount val="1"/>
                <c:pt idx="0">
                  <c:v>C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8:$AB$8</c:f>
                <c:numCache>
                  <c:formatCode>General</c:formatCode>
                  <c:ptCount val="5"/>
                  <c:pt idx="0">
                    <c:v>1.0874999999999999</c:v>
                  </c:pt>
                  <c:pt idx="1">
                    <c:v>0.5233605353864581</c:v>
                  </c:pt>
                  <c:pt idx="2">
                    <c:v>0.63966136874651647</c:v>
                  </c:pt>
                  <c:pt idx="3">
                    <c:v>0.60690471520110401</c:v>
                  </c:pt>
                  <c:pt idx="4">
                    <c:v>0.62599920127744579</c:v>
                  </c:pt>
                </c:numCache>
              </c:numRef>
            </c:plus>
            <c:minus>
              <c:numRef>
                <c:f>'For paper (average) (2)'!$X$8:$AB$8</c:f>
                <c:numCache>
                  <c:formatCode>General</c:formatCode>
                  <c:ptCount val="5"/>
                  <c:pt idx="0">
                    <c:v>1.0874999999999999</c:v>
                  </c:pt>
                  <c:pt idx="1">
                    <c:v>0.5233605353864581</c:v>
                  </c:pt>
                  <c:pt idx="2">
                    <c:v>0.63966136874651647</c:v>
                  </c:pt>
                  <c:pt idx="3">
                    <c:v>0.60690471520110401</c:v>
                  </c:pt>
                  <c:pt idx="4">
                    <c:v>0.62599920127744579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D$8:$H$8</c:f>
              <c:numCache>
                <c:formatCode>General</c:formatCode>
                <c:ptCount val="5"/>
                <c:pt idx="0">
                  <c:v>2.0375000000000001</c:v>
                </c:pt>
                <c:pt idx="1">
                  <c:v>0.98749999999999993</c:v>
                </c:pt>
                <c:pt idx="2">
                  <c:v>2.2999999999999998</c:v>
                </c:pt>
                <c:pt idx="3">
                  <c:v>2.1</c:v>
                </c:pt>
                <c:pt idx="4">
                  <c:v>5.4249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5B9-41C1-BED1-F2151402F9B0}"/>
            </c:ext>
          </c:extLst>
        </c:ser>
        <c:ser>
          <c:idx val="1"/>
          <c:order val="1"/>
          <c:tx>
            <c:strRef>
              <c:f>'For paper (average) (2)'!$I$4</c:f>
              <c:strCache>
                <c:ptCount val="1"/>
                <c:pt idx="0">
                  <c:v>G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AC$8:$AG$8</c:f>
                <c:numCache>
                  <c:formatCode>General</c:formatCode>
                  <c:ptCount val="5"/>
                  <c:pt idx="0">
                    <c:v>0.72121425388021843</c:v>
                  </c:pt>
                  <c:pt idx="1">
                    <c:v>0.26239283526803853</c:v>
                  </c:pt>
                  <c:pt idx="2">
                    <c:v>0.2876629972728505</c:v>
                  </c:pt>
                  <c:pt idx="3">
                    <c:v>0.61388109597869178</c:v>
                  </c:pt>
                  <c:pt idx="4">
                    <c:v>0.2976575213227442</c:v>
                  </c:pt>
                </c:numCache>
              </c:numRef>
            </c:plus>
            <c:minus>
              <c:numRef>
                <c:f>'For paper (average) (2)'!$AC$8:$AG$8</c:f>
                <c:numCache>
                  <c:formatCode>General</c:formatCode>
                  <c:ptCount val="5"/>
                  <c:pt idx="0">
                    <c:v>0.72121425388021843</c:v>
                  </c:pt>
                  <c:pt idx="1">
                    <c:v>0.26239283526803853</c:v>
                  </c:pt>
                  <c:pt idx="2">
                    <c:v>0.2876629972728505</c:v>
                  </c:pt>
                  <c:pt idx="3">
                    <c:v>0.61388109597869178</c:v>
                  </c:pt>
                  <c:pt idx="4">
                    <c:v>0.297657521322744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I$8:$M$8</c:f>
              <c:numCache>
                <c:formatCode>General</c:formatCode>
                <c:ptCount val="5"/>
                <c:pt idx="0">
                  <c:v>2.9299999999999997</c:v>
                </c:pt>
                <c:pt idx="1">
                  <c:v>0.45999999999999996</c:v>
                </c:pt>
                <c:pt idx="2">
                  <c:v>0.4</c:v>
                </c:pt>
                <c:pt idx="3">
                  <c:v>1.4600000000000002</c:v>
                </c:pt>
                <c:pt idx="4">
                  <c:v>1.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5B9-41C1-BED1-F2151402F9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5942272"/>
        <c:axId val="95943424"/>
      </c:scatterChart>
      <c:valAx>
        <c:axId val="95942272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95943424"/>
        <c:crosses val="autoZero"/>
        <c:crossBetween val="midCat"/>
        <c:majorUnit val="20"/>
      </c:valAx>
      <c:valAx>
        <c:axId val="95943424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VA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95942272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>
                <a:solidFill>
                  <a:schemeClr val="tx1"/>
                </a:solidFill>
              </a:defRPr>
            </a:pPr>
            <a:r>
              <a:rPr lang="en-US" sz="1200" dirty="0">
                <a:solidFill>
                  <a:schemeClr val="tx1"/>
                </a:solidFill>
              </a:rPr>
              <a:t>A) During moving to body weight</a:t>
            </a:r>
            <a:r>
              <a:rPr lang="en-US" sz="1200" baseline="0" dirty="0">
                <a:solidFill>
                  <a:schemeClr val="tx1"/>
                </a:solidFill>
              </a:rPr>
              <a:t> scale</a:t>
            </a:r>
            <a:endParaRPr lang="ja-JP" sz="1200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16431038900700812"/>
          <c:y val="9.5866059263341047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6991278217625608"/>
          <c:y val="0.1304614358329822"/>
          <c:w val="0.7404130361568183"/>
          <c:h val="0.6980031991276773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aper (average) (2)'!$D$4</c:f>
              <c:strCache>
                <c:ptCount val="1"/>
                <c:pt idx="0">
                  <c:v>C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5:$AB$5</c:f>
                <c:numCache>
                  <c:formatCode>General</c:formatCode>
                  <c:ptCount val="5"/>
                  <c:pt idx="0">
                    <c:v>0.23935677693908453</c:v>
                  </c:pt>
                  <c:pt idx="1">
                    <c:v>0.23935677693908453</c:v>
                  </c:pt>
                  <c:pt idx="2">
                    <c:v>0.20412414523193151</c:v>
                  </c:pt>
                  <c:pt idx="3">
                    <c:v>0.25</c:v>
                  </c:pt>
                  <c:pt idx="4">
                    <c:v>0.4330127018922193</c:v>
                  </c:pt>
                </c:numCache>
              </c:numRef>
            </c:plus>
            <c:minus>
              <c:numRef>
                <c:f>'For paper (average) (2)'!$X$5:$AB$5</c:f>
                <c:numCache>
                  <c:formatCode>General</c:formatCode>
                  <c:ptCount val="5"/>
                  <c:pt idx="0">
                    <c:v>0.23935677693908453</c:v>
                  </c:pt>
                  <c:pt idx="1">
                    <c:v>0.23935677693908453</c:v>
                  </c:pt>
                  <c:pt idx="2">
                    <c:v>0.20412414523193151</c:v>
                  </c:pt>
                  <c:pt idx="3">
                    <c:v>0.25</c:v>
                  </c:pt>
                  <c:pt idx="4">
                    <c:v>0.433012701892219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D$5:$H$5</c:f>
              <c:numCache>
                <c:formatCode>General</c:formatCode>
                <c:ptCount val="5"/>
                <c:pt idx="0">
                  <c:v>1.375</c:v>
                </c:pt>
                <c:pt idx="1">
                  <c:v>1.625</c:v>
                </c:pt>
                <c:pt idx="2">
                  <c:v>1.5</c:v>
                </c:pt>
                <c:pt idx="3">
                  <c:v>2.25</c:v>
                </c:pt>
                <c:pt idx="4">
                  <c:v>1.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CBF-4E5D-9D2C-6B1C899B3402}"/>
            </c:ext>
          </c:extLst>
        </c:ser>
        <c:ser>
          <c:idx val="1"/>
          <c:order val="1"/>
          <c:tx>
            <c:strRef>
              <c:f>'For paper (average) (2)'!$I$4</c:f>
              <c:strCache>
                <c:ptCount val="1"/>
                <c:pt idx="0">
                  <c:v>G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AC$5:$AG$5</c:f>
                <c:numCache>
                  <c:formatCode>General</c:formatCode>
                  <c:ptCount val="5"/>
                  <c:pt idx="0">
                    <c:v>9.9999999999999825E-2</c:v>
                  </c:pt>
                  <c:pt idx="1">
                    <c:v>0.18708286933869697</c:v>
                  </c:pt>
                  <c:pt idx="2">
                    <c:v>0.20000000000000009</c:v>
                  </c:pt>
                  <c:pt idx="3">
                    <c:v>0.20000000000000009</c:v>
                  </c:pt>
                  <c:pt idx="4">
                    <c:v>0.10000000000000005</c:v>
                  </c:pt>
                </c:numCache>
              </c:numRef>
            </c:plus>
            <c:minus>
              <c:numRef>
                <c:f>'For paper (average) (2)'!$AC$5:$AG$5</c:f>
                <c:numCache>
                  <c:formatCode>General</c:formatCode>
                  <c:ptCount val="5"/>
                  <c:pt idx="0">
                    <c:v>9.9999999999999825E-2</c:v>
                  </c:pt>
                  <c:pt idx="1">
                    <c:v>0.18708286933869697</c:v>
                  </c:pt>
                  <c:pt idx="2">
                    <c:v>0.20000000000000009</c:v>
                  </c:pt>
                  <c:pt idx="3">
                    <c:v>0.20000000000000009</c:v>
                  </c:pt>
                  <c:pt idx="4">
                    <c:v>0.10000000000000005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I$5:$M$5</c:f>
              <c:numCache>
                <c:formatCode>General</c:formatCode>
                <c:ptCount val="5"/>
                <c:pt idx="0">
                  <c:v>1.9</c:v>
                </c:pt>
                <c:pt idx="1">
                  <c:v>1.4</c:v>
                </c:pt>
                <c:pt idx="2">
                  <c:v>1.3</c:v>
                </c:pt>
                <c:pt idx="3">
                  <c:v>1.7</c:v>
                </c:pt>
                <c:pt idx="4">
                  <c:v>1.10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CBF-4E5D-9D2C-6B1C899B34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5805120"/>
        <c:axId val="125805696"/>
      </c:scatterChart>
      <c:valAx>
        <c:axId val="125805120"/>
        <c:scaling>
          <c:orientation val="minMax"/>
          <c:min val="0"/>
        </c:scaling>
        <c:delete val="0"/>
        <c:axPos val="b"/>
        <c:numFmt formatCode="#,##0_);\(#,##0\)" sourceLinked="0"/>
        <c:majorTickMark val="out"/>
        <c:minorTickMark val="none"/>
        <c:tickLblPos val="nextTo"/>
        <c:crossAx val="125805696"/>
        <c:crosses val="autoZero"/>
        <c:crossBetween val="midCat"/>
        <c:majorUnit val="20"/>
      </c:valAx>
      <c:valAx>
        <c:axId val="125805696"/>
        <c:scaling>
          <c:orientation val="minMax"/>
          <c:max val="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Score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25805120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E)</a:t>
            </a:r>
            <a:r>
              <a:rPr lang="en-US" sz="1200" baseline="0" dirty="0"/>
              <a:t> </a:t>
            </a:r>
            <a:r>
              <a:rPr lang="en-US" sz="1200" dirty="0"/>
              <a:t>Overall movement</a:t>
            </a:r>
            <a:endParaRPr lang="ja-JP" sz="1200" dirty="0"/>
          </a:p>
        </c:rich>
      </c:tx>
      <c:layout>
        <c:manualLayout>
          <c:xMode val="edge"/>
          <c:yMode val="edge"/>
          <c:x val="0.22448776471135012"/>
          <c:y val="6.35346814355185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904654639689025"/>
          <c:y val="0.1304614358329822"/>
          <c:w val="0.75128263397455053"/>
          <c:h val="0.6980031991276773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aper (average) (2)'!$D$4</c:f>
              <c:strCache>
                <c:ptCount val="1"/>
                <c:pt idx="0">
                  <c:v>C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13:$AB$13</c:f>
                <c:numCache>
                  <c:formatCode>General</c:formatCode>
                  <c:ptCount val="5"/>
                  <c:pt idx="0">
                    <c:v>0.37989856102210573</c:v>
                  </c:pt>
                  <c:pt idx="1">
                    <c:v>0.58036446881823067</c:v>
                  </c:pt>
                  <c:pt idx="2">
                    <c:v>0.17853571071357116</c:v>
                  </c:pt>
                  <c:pt idx="3">
                    <c:v>0.30990589969645094</c:v>
                  </c:pt>
                  <c:pt idx="4">
                    <c:v>0.39442732748463116</c:v>
                  </c:pt>
                </c:numCache>
              </c:numRef>
            </c:plus>
            <c:minus>
              <c:numRef>
                <c:f>'For paper (average) (2)'!$X$13:$AB$13</c:f>
                <c:numCache>
                  <c:formatCode>General</c:formatCode>
                  <c:ptCount val="5"/>
                  <c:pt idx="0">
                    <c:v>0.37989856102210573</c:v>
                  </c:pt>
                  <c:pt idx="1">
                    <c:v>0.58036446881823067</c:v>
                  </c:pt>
                  <c:pt idx="2">
                    <c:v>0.17853571071357116</c:v>
                  </c:pt>
                  <c:pt idx="3">
                    <c:v>0.30990589969645094</c:v>
                  </c:pt>
                  <c:pt idx="4">
                    <c:v>0.3944273274846311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D$13:$H$13</c:f>
              <c:numCache>
                <c:formatCode>General</c:formatCode>
                <c:ptCount val="5"/>
                <c:pt idx="0">
                  <c:v>6.6125000000000007</c:v>
                </c:pt>
                <c:pt idx="1">
                  <c:v>5.8125</c:v>
                </c:pt>
                <c:pt idx="2">
                  <c:v>5.125</c:v>
                </c:pt>
                <c:pt idx="3">
                  <c:v>5.9250000000000007</c:v>
                </c:pt>
                <c:pt idx="4">
                  <c:v>6.6624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691-4871-A9F0-E195474EA51A}"/>
            </c:ext>
          </c:extLst>
        </c:ser>
        <c:ser>
          <c:idx val="1"/>
          <c:order val="1"/>
          <c:tx>
            <c:strRef>
              <c:f>'For paper (average) (2)'!$I$4</c:f>
              <c:strCache>
                <c:ptCount val="1"/>
                <c:pt idx="0">
                  <c:v>G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AC$13:$AG$13</c:f>
                <c:numCache>
                  <c:formatCode>General</c:formatCode>
                  <c:ptCount val="5"/>
                  <c:pt idx="0">
                    <c:v>0.46162755550335161</c:v>
                  </c:pt>
                  <c:pt idx="1">
                    <c:v>0.48192323040085955</c:v>
                  </c:pt>
                  <c:pt idx="2">
                    <c:v>0.33563372893676807</c:v>
                  </c:pt>
                  <c:pt idx="3">
                    <c:v>0.78955683772607543</c:v>
                  </c:pt>
                  <c:pt idx="4">
                    <c:v>0.22715633383201134</c:v>
                  </c:pt>
                </c:numCache>
              </c:numRef>
            </c:plus>
            <c:minus>
              <c:numRef>
                <c:f>'For paper (average) (2)'!$AC$13:$AG$13</c:f>
                <c:numCache>
                  <c:formatCode>General</c:formatCode>
                  <c:ptCount val="5"/>
                  <c:pt idx="0">
                    <c:v>0.46162755550335161</c:v>
                  </c:pt>
                  <c:pt idx="1">
                    <c:v>0.48192323040085955</c:v>
                  </c:pt>
                  <c:pt idx="2">
                    <c:v>0.33563372893676807</c:v>
                  </c:pt>
                  <c:pt idx="3">
                    <c:v>0.78955683772607543</c:v>
                  </c:pt>
                  <c:pt idx="4">
                    <c:v>0.2271563338320113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I$13:$M$13</c:f>
              <c:numCache>
                <c:formatCode>General</c:formatCode>
                <c:ptCount val="5"/>
                <c:pt idx="0">
                  <c:v>5.99</c:v>
                </c:pt>
                <c:pt idx="1">
                  <c:v>1.7</c:v>
                </c:pt>
                <c:pt idx="2">
                  <c:v>1.67</c:v>
                </c:pt>
                <c:pt idx="3">
                  <c:v>2.5799999999999996</c:v>
                </c:pt>
                <c:pt idx="4">
                  <c:v>3.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691-4871-A9F0-E195474EA5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5810304"/>
        <c:axId val="125810880"/>
      </c:scatterChart>
      <c:valAx>
        <c:axId val="125810304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125810880"/>
        <c:crosses val="autoZero"/>
        <c:crossBetween val="midCat"/>
        <c:majorUnit val="20"/>
      </c:valAx>
      <c:valAx>
        <c:axId val="125810880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VA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25810304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A) Head movement</a:t>
            </a:r>
            <a:endParaRPr lang="ja-JP" sz="1200" dirty="0"/>
          </a:p>
        </c:rich>
      </c:tx>
      <c:layout>
        <c:manualLayout>
          <c:xMode val="edge"/>
          <c:yMode val="edge"/>
          <c:x val="0.24767592458767312"/>
          <c:y val="4.2862366055106078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904654639689025"/>
          <c:y val="0.1304614358329822"/>
          <c:w val="0.75128263397455053"/>
          <c:h val="0.6980031991276773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aper (average) (2)'!$D$4</c:f>
              <c:strCache>
                <c:ptCount val="1"/>
                <c:pt idx="0">
                  <c:v>C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14:$AB$14</c:f>
                <c:numCache>
                  <c:formatCode>General</c:formatCode>
                  <c:ptCount val="5"/>
                  <c:pt idx="0">
                    <c:v>0.46787418180532109</c:v>
                  </c:pt>
                  <c:pt idx="1">
                    <c:v>0.16393596310754999</c:v>
                  </c:pt>
                  <c:pt idx="2">
                    <c:v>0.3582364210034113</c:v>
                  </c:pt>
                  <c:pt idx="3">
                    <c:v>0.4408207307587364</c:v>
                  </c:pt>
                  <c:pt idx="4">
                    <c:v>0.25576682088704683</c:v>
                  </c:pt>
                </c:numCache>
              </c:numRef>
            </c:plus>
            <c:minus>
              <c:numRef>
                <c:f>'For paper (average) (2)'!$X$14:$AB$14</c:f>
                <c:numCache>
                  <c:formatCode>General</c:formatCode>
                  <c:ptCount val="5"/>
                  <c:pt idx="0">
                    <c:v>0.46787418180532109</c:v>
                  </c:pt>
                  <c:pt idx="1">
                    <c:v>0.16393596310754999</c:v>
                  </c:pt>
                  <c:pt idx="2">
                    <c:v>0.3582364210034113</c:v>
                  </c:pt>
                  <c:pt idx="3">
                    <c:v>0.4408207307587364</c:v>
                  </c:pt>
                  <c:pt idx="4">
                    <c:v>0.2557668208870468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D$14:$H$14</c:f>
              <c:numCache>
                <c:formatCode>General</c:formatCode>
                <c:ptCount val="5"/>
                <c:pt idx="0">
                  <c:v>6.2625000000000002</c:v>
                </c:pt>
                <c:pt idx="1">
                  <c:v>6.875</c:v>
                </c:pt>
                <c:pt idx="2">
                  <c:v>6.25</c:v>
                </c:pt>
                <c:pt idx="3">
                  <c:v>6.1124999999999998</c:v>
                </c:pt>
                <c:pt idx="4">
                  <c:v>6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9C7-41C4-B8E2-6F26167FFEC6}"/>
            </c:ext>
          </c:extLst>
        </c:ser>
        <c:ser>
          <c:idx val="1"/>
          <c:order val="1"/>
          <c:tx>
            <c:strRef>
              <c:f>'For paper (average) (2)'!$I$4</c:f>
              <c:strCache>
                <c:ptCount val="1"/>
                <c:pt idx="0">
                  <c:v>G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AC$14:$AG$14</c:f>
                <c:numCache>
                  <c:formatCode>General</c:formatCode>
                  <c:ptCount val="5"/>
                  <c:pt idx="0">
                    <c:v>0.29000000000000004</c:v>
                  </c:pt>
                  <c:pt idx="1">
                    <c:v>0.54895354994753398</c:v>
                  </c:pt>
                  <c:pt idx="2">
                    <c:v>0.35686131760110962</c:v>
                  </c:pt>
                  <c:pt idx="3">
                    <c:v>0.74809758721706909</c:v>
                  </c:pt>
                  <c:pt idx="4">
                    <c:v>0.54438038171851888</c:v>
                  </c:pt>
                </c:numCache>
              </c:numRef>
            </c:plus>
            <c:minus>
              <c:numRef>
                <c:f>'For paper (average) (2)'!$AC$14:$AG$14</c:f>
                <c:numCache>
                  <c:formatCode>General</c:formatCode>
                  <c:ptCount val="5"/>
                  <c:pt idx="0">
                    <c:v>0.29000000000000004</c:v>
                  </c:pt>
                  <c:pt idx="1">
                    <c:v>0.54895354994753398</c:v>
                  </c:pt>
                  <c:pt idx="2">
                    <c:v>0.35686131760110962</c:v>
                  </c:pt>
                  <c:pt idx="3">
                    <c:v>0.74809758721706909</c:v>
                  </c:pt>
                  <c:pt idx="4">
                    <c:v>0.54438038171851888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I$14:$M$14</c:f>
              <c:numCache>
                <c:formatCode>General</c:formatCode>
                <c:ptCount val="5"/>
                <c:pt idx="0">
                  <c:v>6.51</c:v>
                </c:pt>
                <c:pt idx="1">
                  <c:v>2.4400000000000004</c:v>
                </c:pt>
                <c:pt idx="2">
                  <c:v>2.19</c:v>
                </c:pt>
                <c:pt idx="3">
                  <c:v>3.0300000000000002</c:v>
                </c:pt>
                <c:pt idx="4">
                  <c:v>2.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9C7-41C4-B8E2-6F26167FFE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3062656"/>
        <c:axId val="133063232"/>
      </c:scatterChart>
      <c:valAx>
        <c:axId val="133062656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133063232"/>
        <c:crosses val="autoZero"/>
        <c:crossBetween val="midCat"/>
        <c:majorUnit val="20"/>
      </c:valAx>
      <c:valAx>
        <c:axId val="133063232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VA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33062656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B) Tail flicking</a:t>
            </a:r>
            <a:endParaRPr lang="ja-JP" sz="1200" dirty="0"/>
          </a:p>
        </c:rich>
      </c:tx>
      <c:layout>
        <c:manualLayout>
          <c:xMode val="edge"/>
          <c:yMode val="edge"/>
          <c:x val="0.30217081517050171"/>
          <c:y val="4.297181492569410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904654639689025"/>
          <c:y val="0.1304614358329822"/>
          <c:w val="0.75128263397455053"/>
          <c:h val="0.6980031991276773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aper (average) (2)'!$D$4</c:f>
              <c:strCache>
                <c:ptCount val="1"/>
                <c:pt idx="0">
                  <c:v>C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15:$AB$15</c:f>
                <c:numCache>
                  <c:formatCode>General</c:formatCode>
                  <c:ptCount val="5"/>
                  <c:pt idx="0">
                    <c:v>0.79017403146395582</c:v>
                  </c:pt>
                  <c:pt idx="1">
                    <c:v>1.2641490879902841</c:v>
                  </c:pt>
                  <c:pt idx="2">
                    <c:v>0.49765073093485873</c:v>
                  </c:pt>
                  <c:pt idx="3">
                    <c:v>0.46592202494981122</c:v>
                  </c:pt>
                  <c:pt idx="4">
                    <c:v>0.70396940037665501</c:v>
                  </c:pt>
                </c:numCache>
              </c:numRef>
            </c:plus>
            <c:minus>
              <c:numRef>
                <c:f>'For paper (average) (2)'!$X$15:$AB$15</c:f>
                <c:numCache>
                  <c:formatCode>General</c:formatCode>
                  <c:ptCount val="5"/>
                  <c:pt idx="0">
                    <c:v>0.79017403146395582</c:v>
                  </c:pt>
                  <c:pt idx="1">
                    <c:v>1.2641490879902841</c:v>
                  </c:pt>
                  <c:pt idx="2">
                    <c:v>0.49765073093485873</c:v>
                  </c:pt>
                  <c:pt idx="3">
                    <c:v>0.46592202494981122</c:v>
                  </c:pt>
                  <c:pt idx="4">
                    <c:v>0.70396940037665501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D$15:$H$15</c:f>
              <c:numCache>
                <c:formatCode>General</c:formatCode>
                <c:ptCount val="5"/>
                <c:pt idx="0">
                  <c:v>3.6749999999999998</c:v>
                </c:pt>
                <c:pt idx="1">
                  <c:v>3.0125000000000002</c:v>
                </c:pt>
                <c:pt idx="2">
                  <c:v>3.1625000000000005</c:v>
                </c:pt>
                <c:pt idx="3">
                  <c:v>5.7</c:v>
                </c:pt>
                <c:pt idx="4">
                  <c:v>6.6124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B74-4669-B568-7CC5F2E7DA8D}"/>
            </c:ext>
          </c:extLst>
        </c:ser>
        <c:ser>
          <c:idx val="1"/>
          <c:order val="1"/>
          <c:tx>
            <c:strRef>
              <c:f>'For paper (average) (2)'!$I$4</c:f>
              <c:strCache>
                <c:ptCount val="1"/>
                <c:pt idx="0">
                  <c:v>G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AC$15:$AG$15</c:f>
                <c:numCache>
                  <c:formatCode>General</c:formatCode>
                  <c:ptCount val="5"/>
                  <c:pt idx="0">
                    <c:v>0.53698230883335485</c:v>
                  </c:pt>
                  <c:pt idx="1">
                    <c:v>0.59552497848536967</c:v>
                  </c:pt>
                  <c:pt idx="2">
                    <c:v>0.54092513345194071</c:v>
                  </c:pt>
                  <c:pt idx="3">
                    <c:v>0.6768677862034802</c:v>
                  </c:pt>
                  <c:pt idx="4">
                    <c:v>0.36379939527162436</c:v>
                  </c:pt>
                </c:numCache>
              </c:numRef>
            </c:plus>
            <c:minus>
              <c:numRef>
                <c:f>'For paper (average) (2)'!$AC$15:$AG$15</c:f>
                <c:numCache>
                  <c:formatCode>General</c:formatCode>
                  <c:ptCount val="5"/>
                  <c:pt idx="0">
                    <c:v>0.53698230883335485</c:v>
                  </c:pt>
                  <c:pt idx="1">
                    <c:v>0.59552497848536967</c:v>
                  </c:pt>
                  <c:pt idx="2">
                    <c:v>0.54092513345194071</c:v>
                  </c:pt>
                  <c:pt idx="3">
                    <c:v>0.6768677862034802</c:v>
                  </c:pt>
                  <c:pt idx="4">
                    <c:v>0.3637993952716243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I$15:$M$15</c:f>
              <c:numCache>
                <c:formatCode>General</c:formatCode>
                <c:ptCount val="5"/>
                <c:pt idx="0">
                  <c:v>4.04</c:v>
                </c:pt>
                <c:pt idx="1">
                  <c:v>1.5299999999999998</c:v>
                </c:pt>
                <c:pt idx="2">
                  <c:v>2.06</c:v>
                </c:pt>
                <c:pt idx="3">
                  <c:v>2.9699999999999998</c:v>
                </c:pt>
                <c:pt idx="4">
                  <c:v>5.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B74-4669-B568-7CC5F2E7DA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3064960"/>
        <c:axId val="133065536"/>
      </c:scatterChart>
      <c:valAx>
        <c:axId val="133064960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133065536"/>
        <c:crosses val="autoZero"/>
        <c:crossBetween val="midCat"/>
        <c:majorUnit val="20"/>
      </c:valAx>
      <c:valAx>
        <c:axId val="133065536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VA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33064960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  <c:userShapes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C) Walking / Stepping</a:t>
            </a:r>
            <a:endParaRPr lang="ja-JP" sz="1200" dirty="0"/>
          </a:p>
        </c:rich>
      </c:tx>
      <c:layout>
        <c:manualLayout>
          <c:xMode val="edge"/>
          <c:yMode val="edge"/>
          <c:x val="0.2216127841358578"/>
          <c:y val="4.7746461028549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904654639689025"/>
          <c:y val="0.1304614358329822"/>
          <c:w val="0.75128263397455053"/>
          <c:h val="0.6980031991276773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aper (average) (2)'!$D$4</c:f>
              <c:strCache>
                <c:ptCount val="1"/>
                <c:pt idx="0">
                  <c:v>C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X$16:$AB$16</c:f>
                <c:numCache>
                  <c:formatCode>General</c:formatCode>
                  <c:ptCount val="5"/>
                  <c:pt idx="0">
                    <c:v>0.79066823004342257</c:v>
                  </c:pt>
                  <c:pt idx="1">
                    <c:v>0.69176706098705454</c:v>
                  </c:pt>
                  <c:pt idx="2">
                    <c:v>0.58749999999999991</c:v>
                  </c:pt>
                  <c:pt idx="3">
                    <c:v>0.33750000000000008</c:v>
                  </c:pt>
                  <c:pt idx="4">
                    <c:v>0.44674750512267364</c:v>
                  </c:pt>
                </c:numCache>
              </c:numRef>
            </c:plus>
            <c:minus>
              <c:numRef>
                <c:f>'For paper (average) (2)'!$X$16:$AB$16</c:f>
                <c:numCache>
                  <c:formatCode>General</c:formatCode>
                  <c:ptCount val="5"/>
                  <c:pt idx="0">
                    <c:v>0.79066823004342257</c:v>
                  </c:pt>
                  <c:pt idx="1">
                    <c:v>0.69176706098705454</c:v>
                  </c:pt>
                  <c:pt idx="2">
                    <c:v>0.58749999999999991</c:v>
                  </c:pt>
                  <c:pt idx="3">
                    <c:v>0.33750000000000008</c:v>
                  </c:pt>
                  <c:pt idx="4">
                    <c:v>0.4467475051226736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D$16:$H$16</c:f>
              <c:numCache>
                <c:formatCode>General</c:formatCode>
                <c:ptCount val="5"/>
                <c:pt idx="0">
                  <c:v>7.1375000000000002</c:v>
                </c:pt>
                <c:pt idx="1">
                  <c:v>6.6749999999999998</c:v>
                </c:pt>
                <c:pt idx="2">
                  <c:v>6.5625</c:v>
                </c:pt>
                <c:pt idx="3">
                  <c:v>7.2125000000000004</c:v>
                </c:pt>
                <c:pt idx="4">
                  <c:v>7.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D4B-44F8-886C-E7BEBD00C489}"/>
            </c:ext>
          </c:extLst>
        </c:ser>
        <c:ser>
          <c:idx val="1"/>
          <c:order val="1"/>
          <c:tx>
            <c:strRef>
              <c:f>'For paper (average) (2)'!$I$4</c:f>
              <c:strCache>
                <c:ptCount val="1"/>
                <c:pt idx="0">
                  <c:v>GC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or paper (average) (2)'!$AC$16:$AG$16</c:f>
                <c:numCache>
                  <c:formatCode>General</c:formatCode>
                  <c:ptCount val="5"/>
                  <c:pt idx="0">
                    <c:v>0.38360135557633268</c:v>
                  </c:pt>
                  <c:pt idx="1">
                    <c:v>0.70526590730021832</c:v>
                  </c:pt>
                  <c:pt idx="2">
                    <c:v>0.68161572751807886</c:v>
                  </c:pt>
                  <c:pt idx="3">
                    <c:v>1.0069011868103042</c:v>
                  </c:pt>
                  <c:pt idx="4">
                    <c:v>0.44988887516807941</c:v>
                  </c:pt>
                </c:numCache>
              </c:numRef>
            </c:plus>
            <c:minus>
              <c:numRef>
                <c:f>'For paper (average) (2)'!$AC$16:$AG$16</c:f>
                <c:numCache>
                  <c:formatCode>General</c:formatCode>
                  <c:ptCount val="5"/>
                  <c:pt idx="0">
                    <c:v>0.38360135557633268</c:v>
                  </c:pt>
                  <c:pt idx="1">
                    <c:v>0.70526590730021832</c:v>
                  </c:pt>
                  <c:pt idx="2">
                    <c:v>0.68161572751807886</c:v>
                  </c:pt>
                  <c:pt idx="3">
                    <c:v>1.0069011868103042</c:v>
                  </c:pt>
                  <c:pt idx="4">
                    <c:v>0.44988887516807941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For paper (average) (2)'!$D$2:$H$2</c:f>
              <c:numCache>
                <c:formatCode>General</c:formatCode>
                <c:ptCount val="5"/>
                <c:pt idx="0">
                  <c:v>0</c:v>
                </c:pt>
                <c:pt idx="1">
                  <c:v>38</c:v>
                </c:pt>
                <c:pt idx="2">
                  <c:v>52</c:v>
                </c:pt>
                <c:pt idx="3">
                  <c:v>72</c:v>
                </c:pt>
                <c:pt idx="4">
                  <c:v>86</c:v>
                </c:pt>
              </c:numCache>
            </c:numRef>
          </c:xVal>
          <c:yVal>
            <c:numRef>
              <c:f>'For paper (average) (2)'!$I$16:$M$16</c:f>
              <c:numCache>
                <c:formatCode>General</c:formatCode>
                <c:ptCount val="5"/>
                <c:pt idx="0">
                  <c:v>8.0800000000000018</c:v>
                </c:pt>
                <c:pt idx="1">
                  <c:v>1.6800000000000002</c:v>
                </c:pt>
                <c:pt idx="2">
                  <c:v>1.5100000000000002</c:v>
                </c:pt>
                <c:pt idx="3">
                  <c:v>2.7600000000000002</c:v>
                </c:pt>
                <c:pt idx="4">
                  <c:v>3.1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D4B-44F8-886C-E7BEBD00C4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3067264"/>
        <c:axId val="133067840"/>
      </c:scatterChart>
      <c:valAx>
        <c:axId val="133067264"/>
        <c:scaling>
          <c:orientation val="minMax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133067840"/>
        <c:crosses val="autoZero"/>
        <c:crossBetween val="midCat"/>
        <c:majorUnit val="20"/>
      </c:valAx>
      <c:valAx>
        <c:axId val="133067840"/>
        <c:scaling>
          <c:orientation val="minMax"/>
          <c:max val="1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VAS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33067264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Times New Roman" pitchFamily="18" charset="0"/>
          <a:cs typeface="Times New Roman" pitchFamily="18" charset="0"/>
        </a:defRPr>
      </a:pPr>
      <a:endParaRPr lang="ja-JP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5935</cdr:x>
      <cdr:y>0.39557</cdr:y>
    </cdr:from>
    <cdr:to>
      <cdr:x>1</cdr:x>
      <cdr:y>0.58638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04D4E001-C55A-4C8C-9538-1DB571744DC0}"/>
            </a:ext>
          </a:extLst>
        </cdr:cNvPr>
        <cdr:cNvSpPr txBox="1"/>
      </cdr:nvSpPr>
      <cdr:spPr>
        <a:xfrm xmlns:a="http://schemas.openxmlformats.org/drawingml/2006/main">
          <a:off x="1462481" y="1052736"/>
          <a:ext cx="1152128" cy="50783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: P &lt; 0.01</a:t>
          </a:r>
        </a:p>
        <a:p xmlns:a="http://schemas.openxmlformats.org/drawingml/2006/main">
          <a:r>
            <a: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S: P = 0.26</a:t>
          </a:r>
        </a:p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 × S: P = 0.42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21994</cdr:x>
      <cdr:y>0.24283</cdr:y>
    </cdr:from>
    <cdr:to>
      <cdr:x>0.74958</cdr:x>
      <cdr:y>0.50227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76DE0158-A72C-4D6C-B195-02660591C8F0}"/>
            </a:ext>
          </a:extLst>
        </cdr:cNvPr>
        <cdr:cNvSpPr txBox="1"/>
      </cdr:nvSpPr>
      <cdr:spPr>
        <a:xfrm xmlns:a="http://schemas.openxmlformats.org/drawingml/2006/main">
          <a:off x="478427" y="475328"/>
          <a:ext cx="1152128" cy="50783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: P = 0.93</a:t>
          </a:r>
        </a:p>
        <a:p xmlns:a="http://schemas.openxmlformats.org/drawingml/2006/main">
          <a:r>
            <a: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S: P &lt; 0.01</a:t>
          </a:r>
        </a:p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 × S: P &lt; 0.01 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11.xml><?xml version="1.0" encoding="utf-8"?>
<c:userShapes xmlns:c="http://schemas.openxmlformats.org/drawingml/2006/chart">
  <cdr:relSizeAnchor xmlns:cdr="http://schemas.openxmlformats.org/drawingml/2006/chartDrawing">
    <cdr:from>
      <cdr:x>0.28064</cdr:x>
      <cdr:y>0.19516</cdr:y>
    </cdr:from>
    <cdr:to>
      <cdr:x>0.80855</cdr:x>
      <cdr:y>0.4546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76DE0158-A72C-4D6C-B195-02660591C8F0}"/>
            </a:ext>
          </a:extLst>
        </cdr:cNvPr>
        <cdr:cNvSpPr txBox="1"/>
      </cdr:nvSpPr>
      <cdr:spPr>
        <a:xfrm xmlns:a="http://schemas.openxmlformats.org/drawingml/2006/main">
          <a:off x="612485" y="382016"/>
          <a:ext cx="1152128" cy="50783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: P = 0.09</a:t>
          </a:r>
        </a:p>
        <a:p xmlns:a="http://schemas.openxmlformats.org/drawingml/2006/main">
          <a:r>
            <a: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S: P &lt; 0.01</a:t>
          </a:r>
        </a:p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 × S: P = 0.03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12.xml><?xml version="1.0" encoding="utf-8"?>
<c:userShapes xmlns:c="http://schemas.openxmlformats.org/drawingml/2006/chart">
  <cdr:relSizeAnchor xmlns:cdr="http://schemas.openxmlformats.org/drawingml/2006/chartDrawing">
    <cdr:from>
      <cdr:x>0.47036</cdr:x>
      <cdr:y>0.15838</cdr:y>
    </cdr:from>
    <cdr:to>
      <cdr:x>1</cdr:x>
      <cdr:y>0.41781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76DE0158-A72C-4D6C-B195-02660591C8F0}"/>
            </a:ext>
          </a:extLst>
        </cdr:cNvPr>
        <cdr:cNvSpPr txBox="1"/>
      </cdr:nvSpPr>
      <cdr:spPr>
        <a:xfrm xmlns:a="http://schemas.openxmlformats.org/drawingml/2006/main">
          <a:off x="1023165" y="310008"/>
          <a:ext cx="1152128" cy="50783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: P = 0.02</a:t>
          </a:r>
        </a:p>
        <a:p xmlns:a="http://schemas.openxmlformats.org/drawingml/2006/main">
          <a:r>
            <a: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S: P = 0.10</a:t>
          </a:r>
        </a:p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 × S: P = 0.10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13.xml><?xml version="1.0" encoding="utf-8"?>
<c:userShapes xmlns:c="http://schemas.openxmlformats.org/drawingml/2006/chart">
  <cdr:relSizeAnchor xmlns:cdr="http://schemas.openxmlformats.org/drawingml/2006/chartDrawing">
    <cdr:from>
      <cdr:x>0.18967</cdr:x>
      <cdr:y>0.23865</cdr:y>
    </cdr:from>
    <cdr:to>
      <cdr:x>0.71757</cdr:x>
      <cdr:y>0.49809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76DE0158-A72C-4D6C-B195-02660591C8F0}"/>
            </a:ext>
          </a:extLst>
        </cdr:cNvPr>
        <cdr:cNvSpPr txBox="1"/>
      </cdr:nvSpPr>
      <cdr:spPr>
        <a:xfrm xmlns:a="http://schemas.openxmlformats.org/drawingml/2006/main">
          <a:off x="413936" y="467148"/>
          <a:ext cx="1152128" cy="50783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: P = 0.22</a:t>
          </a:r>
        </a:p>
        <a:p xmlns:a="http://schemas.openxmlformats.org/drawingml/2006/main">
          <a:r>
            <a: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S: P = 0.02</a:t>
          </a:r>
        </a:p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 × S: P = 0.07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14.xml><?xml version="1.0" encoding="utf-8"?>
<c:userShapes xmlns:c="http://schemas.openxmlformats.org/drawingml/2006/chart">
  <cdr:relSizeAnchor xmlns:cdr="http://schemas.openxmlformats.org/drawingml/2006/chartDrawing">
    <cdr:from>
      <cdr:x>0.45906</cdr:x>
      <cdr:y>0.21679</cdr:y>
    </cdr:from>
    <cdr:to>
      <cdr:x>0.9887</cdr:x>
      <cdr:y>0.47507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76DE0158-A72C-4D6C-B195-02660591C8F0}"/>
            </a:ext>
          </a:extLst>
        </cdr:cNvPr>
        <cdr:cNvSpPr txBox="1"/>
      </cdr:nvSpPr>
      <cdr:spPr>
        <a:xfrm xmlns:a="http://schemas.openxmlformats.org/drawingml/2006/main">
          <a:off x="998594" y="426257"/>
          <a:ext cx="1152128" cy="50783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: P = 0.23</a:t>
          </a:r>
        </a:p>
        <a:p xmlns:a="http://schemas.openxmlformats.org/drawingml/2006/main">
          <a:r>
            <a: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S: P = 0.71</a:t>
          </a:r>
        </a:p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 × S: P = 0.14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15.xml><?xml version="1.0" encoding="utf-8"?>
<c:userShapes xmlns:c="http://schemas.openxmlformats.org/drawingml/2006/chart">
  <cdr:relSizeAnchor xmlns:cdr="http://schemas.openxmlformats.org/drawingml/2006/chartDrawing">
    <cdr:from>
      <cdr:x>0.20834</cdr:x>
      <cdr:y>0.24172</cdr:y>
    </cdr:from>
    <cdr:to>
      <cdr:x>0.73701</cdr:x>
      <cdr:y>0.5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76DE0158-A72C-4D6C-B195-02660591C8F0}"/>
            </a:ext>
          </a:extLst>
        </cdr:cNvPr>
        <cdr:cNvSpPr txBox="1"/>
      </cdr:nvSpPr>
      <cdr:spPr>
        <a:xfrm xmlns:a="http://schemas.openxmlformats.org/drawingml/2006/main">
          <a:off x="454045" y="475265"/>
          <a:ext cx="1152128" cy="50783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: P &lt; 0.01</a:t>
          </a:r>
        </a:p>
        <a:p xmlns:a="http://schemas.openxmlformats.org/drawingml/2006/main">
          <a:r>
            <a: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S: P = 0.31</a:t>
          </a:r>
        </a:p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 × S: P &lt; 0.01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7342</cdr:x>
      <cdr:y>0.18333</cdr:y>
    </cdr:from>
    <cdr:to>
      <cdr:x>0.61288</cdr:x>
      <cdr:y>0.37534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566D23E7-FC90-4785-85E1-BE71A750E1A7}"/>
            </a:ext>
          </a:extLst>
        </cdr:cNvPr>
        <cdr:cNvSpPr txBox="1"/>
      </cdr:nvSpPr>
      <cdr:spPr>
        <a:xfrm xmlns:a="http://schemas.openxmlformats.org/drawingml/2006/main">
          <a:off x="454660" y="484860"/>
          <a:ext cx="1152128" cy="50783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: P &lt; 0.01</a:t>
          </a:r>
        </a:p>
        <a:p xmlns:a="http://schemas.openxmlformats.org/drawingml/2006/main">
          <a:r>
            <a: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S: P = 0.15</a:t>
          </a:r>
        </a:p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 × S: P = 0.35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18089</cdr:x>
      <cdr:y>0.13517</cdr:y>
    </cdr:from>
    <cdr:to>
      <cdr:x>0.62154</cdr:x>
      <cdr:y>0.32599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7115E101-8F9B-4151-8FA4-D380615426C6}"/>
            </a:ext>
          </a:extLst>
        </cdr:cNvPr>
        <cdr:cNvSpPr txBox="1"/>
      </cdr:nvSpPr>
      <cdr:spPr>
        <a:xfrm xmlns:a="http://schemas.openxmlformats.org/drawingml/2006/main">
          <a:off x="472960" y="359744"/>
          <a:ext cx="1152128" cy="50783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: P &lt; 0.01</a:t>
          </a:r>
        </a:p>
        <a:p xmlns:a="http://schemas.openxmlformats.org/drawingml/2006/main">
          <a:r>
            <a: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S: P = 0.01</a:t>
          </a:r>
        </a:p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 × S: P = 0.10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19976</cdr:x>
      <cdr:y>0.34648</cdr:y>
    </cdr:from>
    <cdr:to>
      <cdr:x>0.64041</cdr:x>
      <cdr:y>0.53875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2BB4767F-8411-4AA6-8AEE-7158249C16D7}"/>
            </a:ext>
          </a:extLst>
        </cdr:cNvPr>
        <cdr:cNvSpPr txBox="1"/>
      </cdr:nvSpPr>
      <cdr:spPr>
        <a:xfrm xmlns:a="http://schemas.openxmlformats.org/drawingml/2006/main">
          <a:off x="522303" y="915137"/>
          <a:ext cx="1152128" cy="50783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: P &lt; 0.01</a:t>
          </a:r>
        </a:p>
        <a:p xmlns:a="http://schemas.openxmlformats.org/drawingml/2006/main">
          <a:r>
            <a: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S: P &lt; 0.01</a:t>
          </a:r>
        </a:p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 × S: P &lt; 0.01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3128</cdr:x>
      <cdr:y>0.17013</cdr:y>
    </cdr:from>
    <cdr:to>
      <cdr:x>0.77816</cdr:x>
      <cdr:y>0.36105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7115E101-8F9B-4151-8FA4-D380615426C6}"/>
            </a:ext>
          </a:extLst>
        </cdr:cNvPr>
        <cdr:cNvSpPr txBox="1"/>
      </cdr:nvSpPr>
      <cdr:spPr>
        <a:xfrm xmlns:a="http://schemas.openxmlformats.org/drawingml/2006/main">
          <a:off x="774403" y="452531"/>
          <a:ext cx="1152128" cy="50783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: P &lt; 0.01</a:t>
          </a:r>
        </a:p>
        <a:p xmlns:a="http://schemas.openxmlformats.org/drawingml/2006/main">
          <a:r>
            <a: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S: P = 0.01</a:t>
          </a:r>
        </a:p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 × S: P = 0.80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46574</cdr:x>
      <cdr:y>0.14841</cdr:y>
    </cdr:from>
    <cdr:to>
      <cdr:x>0.92958</cdr:x>
      <cdr:y>0.33884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76DE0158-A72C-4D6C-B195-02660591C8F0}"/>
            </a:ext>
          </a:extLst>
        </cdr:cNvPr>
        <cdr:cNvSpPr txBox="1"/>
      </cdr:nvSpPr>
      <cdr:spPr>
        <a:xfrm xmlns:a="http://schemas.openxmlformats.org/drawingml/2006/main">
          <a:off x="1156853" y="395752"/>
          <a:ext cx="1152128" cy="50783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: P &lt; 0.01</a:t>
          </a:r>
        </a:p>
        <a:p xmlns:a="http://schemas.openxmlformats.org/drawingml/2006/main">
          <a:r>
            <a: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S: P = 0.55</a:t>
          </a:r>
        </a:p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 × S: P = 0.39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19305</cdr:x>
      <cdr:y>0.21411</cdr:y>
    </cdr:from>
    <cdr:to>
      <cdr:x>0.65841</cdr:x>
      <cdr:y>0.40503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76DE0158-A72C-4D6C-B195-02660591C8F0}"/>
            </a:ext>
          </a:extLst>
        </cdr:cNvPr>
        <cdr:cNvSpPr txBox="1"/>
      </cdr:nvSpPr>
      <cdr:spPr>
        <a:xfrm xmlns:a="http://schemas.openxmlformats.org/drawingml/2006/main">
          <a:off x="477944" y="569500"/>
          <a:ext cx="1152128" cy="50783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: P &lt; 0.01</a:t>
          </a:r>
        </a:p>
        <a:p xmlns:a="http://schemas.openxmlformats.org/drawingml/2006/main">
          <a:r>
            <a: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S: P &lt; 0.01</a:t>
          </a:r>
        </a:p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 × S: P &lt; 0.01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58056</cdr:x>
      <cdr:y>0.34218</cdr:y>
    </cdr:from>
    <cdr:to>
      <cdr:x>1</cdr:x>
      <cdr:y>0.56238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76DE0158-A72C-4D6C-B195-02660591C8F0}"/>
            </a:ext>
          </a:extLst>
        </cdr:cNvPr>
        <cdr:cNvSpPr txBox="1"/>
      </cdr:nvSpPr>
      <cdr:spPr>
        <a:xfrm xmlns:a="http://schemas.openxmlformats.org/drawingml/2006/main">
          <a:off x="1328455" y="789144"/>
          <a:ext cx="959782" cy="50783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: P &lt; 0.01</a:t>
          </a:r>
        </a:p>
        <a:p xmlns:a="http://schemas.openxmlformats.org/drawingml/2006/main">
          <a:r>
            <a: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S: P = 0.14</a:t>
          </a:r>
        </a:p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 × S: P = 0.96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22214</cdr:x>
      <cdr:y>0.14577</cdr:y>
    </cdr:from>
    <cdr:to>
      <cdr:x>0.6875</cdr:x>
      <cdr:y>0.33754</cdr:y>
    </cdr:to>
    <cdr:sp macro="" textlink="">
      <cdr:nvSpPr>
        <cdr:cNvPr id="2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76DE0158-A72C-4D6C-B195-02660591C8F0}"/>
            </a:ext>
          </a:extLst>
        </cdr:cNvPr>
        <cdr:cNvSpPr txBox="1"/>
      </cdr:nvSpPr>
      <cdr:spPr>
        <a:xfrm xmlns:a="http://schemas.openxmlformats.org/drawingml/2006/main">
          <a:off x="549952" y="385994"/>
          <a:ext cx="1152128" cy="50783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: P &lt; 0.01</a:t>
          </a:r>
        </a:p>
        <a:p xmlns:a="http://schemas.openxmlformats.org/drawingml/2006/main">
          <a:r>
            <a:rPr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S: P = 0.17</a:t>
          </a:r>
        </a:p>
        <a:p xmlns:a="http://schemas.openxmlformats.org/drawingml/2006/main">
          <a:r>
            <a:rPr kumimoji="1" lang="en-US" altLang="ja-JP" sz="900" dirty="0">
              <a:latin typeface="Times New Roman" panose="02020603050405020304" pitchFamily="18" charset="0"/>
              <a:cs typeface="Times New Roman" panose="02020603050405020304" pitchFamily="18" charset="0"/>
            </a:rPr>
            <a:t>T × S: P = 0.89</a:t>
          </a:r>
          <a:endParaRPr kumimoji="1" lang="ja-JP" altLang="en-US" sz="9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FD60F-5750-40B3-B0F9-3AA46A7F4DCC}" type="datetimeFigureOut">
              <a:rPr kumimoji="1" lang="ja-JP" altLang="en-US" smtClean="0"/>
              <a:t>2021/6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4DE9-A6D9-4D5F-96F3-C78F102E5A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9027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FD60F-5750-40B3-B0F9-3AA46A7F4DCC}" type="datetimeFigureOut">
              <a:rPr kumimoji="1" lang="ja-JP" altLang="en-US" smtClean="0"/>
              <a:t>2021/6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4DE9-A6D9-4D5F-96F3-C78F102E5A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9439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FD60F-5750-40B3-B0F9-3AA46A7F4DCC}" type="datetimeFigureOut">
              <a:rPr kumimoji="1" lang="ja-JP" altLang="en-US" smtClean="0"/>
              <a:t>2021/6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4DE9-A6D9-4D5F-96F3-C78F102E5A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7374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FD60F-5750-40B3-B0F9-3AA46A7F4DCC}" type="datetimeFigureOut">
              <a:rPr kumimoji="1" lang="ja-JP" altLang="en-US" smtClean="0"/>
              <a:t>2021/6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4DE9-A6D9-4D5F-96F3-C78F102E5A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7656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FD60F-5750-40B3-B0F9-3AA46A7F4DCC}" type="datetimeFigureOut">
              <a:rPr kumimoji="1" lang="ja-JP" altLang="en-US" smtClean="0"/>
              <a:t>2021/6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4DE9-A6D9-4D5F-96F3-C78F102E5A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69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FD60F-5750-40B3-B0F9-3AA46A7F4DCC}" type="datetimeFigureOut">
              <a:rPr kumimoji="1" lang="ja-JP" altLang="en-US" smtClean="0"/>
              <a:t>2021/6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4DE9-A6D9-4D5F-96F3-C78F102E5A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7535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FD60F-5750-40B3-B0F9-3AA46A7F4DCC}" type="datetimeFigureOut">
              <a:rPr kumimoji="1" lang="ja-JP" altLang="en-US" smtClean="0"/>
              <a:t>2021/6/2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4DE9-A6D9-4D5F-96F3-C78F102E5A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375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FD60F-5750-40B3-B0F9-3AA46A7F4DCC}" type="datetimeFigureOut">
              <a:rPr kumimoji="1" lang="ja-JP" altLang="en-US" smtClean="0"/>
              <a:t>2021/6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4DE9-A6D9-4D5F-96F3-C78F102E5A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8372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FD60F-5750-40B3-B0F9-3AA46A7F4DCC}" type="datetimeFigureOut">
              <a:rPr kumimoji="1" lang="ja-JP" altLang="en-US" smtClean="0"/>
              <a:t>2021/6/2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4DE9-A6D9-4D5F-96F3-C78F102E5A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868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FD60F-5750-40B3-B0F9-3AA46A7F4DCC}" type="datetimeFigureOut">
              <a:rPr kumimoji="1" lang="ja-JP" altLang="en-US" smtClean="0"/>
              <a:t>2021/6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4DE9-A6D9-4D5F-96F3-C78F102E5A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0274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FD60F-5750-40B3-B0F9-3AA46A7F4DCC}" type="datetimeFigureOut">
              <a:rPr kumimoji="1" lang="ja-JP" altLang="en-US" smtClean="0"/>
              <a:t>2021/6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B04DE9-A6D9-4D5F-96F3-C78F102E5A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24671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4FD60F-5750-40B3-B0F9-3AA46A7F4DCC}" type="datetimeFigureOut">
              <a:rPr kumimoji="1" lang="ja-JP" altLang="en-US" smtClean="0"/>
              <a:t>2021/6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B04DE9-A6D9-4D5F-96F3-C78F102E5A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5605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0.xml"/><Relationship Id="rId5" Type="http://schemas.openxmlformats.org/officeDocument/2006/relationships/chart" Target="../charts/chart9.xml"/><Relationship Id="rId4" Type="http://schemas.openxmlformats.org/officeDocument/2006/relationships/chart" Target="../charts/chart8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7" Type="http://schemas.openxmlformats.org/officeDocument/2006/relationships/chart" Target="../charts/chart16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5.xml"/><Relationship Id="rId5" Type="http://schemas.openxmlformats.org/officeDocument/2006/relationships/chart" Target="../charts/chart14.xml"/><Relationship Id="rId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グループ化 37"/>
          <p:cNvGrpSpPr/>
          <p:nvPr/>
        </p:nvGrpSpPr>
        <p:grpSpPr>
          <a:xfrm>
            <a:off x="1115616" y="257597"/>
            <a:ext cx="7128792" cy="4896544"/>
            <a:chOff x="-12928" y="-19052"/>
            <a:chExt cx="11461174" cy="6038013"/>
          </a:xfrm>
        </p:grpSpPr>
        <p:graphicFrame>
          <p:nvGraphicFramePr>
            <p:cNvPr id="39" name="グラフ 3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85030541"/>
                </p:ext>
              </p:extLst>
            </p:nvPr>
          </p:nvGraphicFramePr>
          <p:xfrm>
            <a:off x="3841575" y="-19052"/>
            <a:ext cx="3762374" cy="306568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0" name="グラフ 3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59842709"/>
                </p:ext>
              </p:extLst>
            </p:nvPr>
          </p:nvGraphicFramePr>
          <p:xfrm>
            <a:off x="-12928" y="2951549"/>
            <a:ext cx="3772580" cy="304663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1" name="グラフ 4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3040154"/>
                </p:ext>
              </p:extLst>
            </p:nvPr>
          </p:nvGraphicFramePr>
          <p:xfrm>
            <a:off x="3831458" y="2953272"/>
            <a:ext cx="3762374" cy="306568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42" name="グラフ 4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04104657"/>
                </p:ext>
              </p:extLst>
            </p:nvPr>
          </p:nvGraphicFramePr>
          <p:xfrm>
            <a:off x="7685872" y="16327"/>
            <a:ext cx="3762374" cy="30425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43" name="グラフ 4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7838909"/>
                </p:ext>
              </p:extLst>
            </p:nvPr>
          </p:nvGraphicFramePr>
          <p:xfrm>
            <a:off x="2721" y="6803"/>
            <a:ext cx="3756932" cy="305208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115E101-8F9B-4151-8FA4-D380615426C6}"/>
              </a:ext>
            </a:extLst>
          </p:cNvPr>
          <p:cNvSpPr txBox="1"/>
          <p:nvPr/>
        </p:nvSpPr>
        <p:spPr>
          <a:xfrm>
            <a:off x="1519208" y="928416"/>
            <a:ext cx="115212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: P = 0.05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: P &lt; 0.05</a:t>
            </a:r>
          </a:p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× S: P = 0.36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18CE37F-9E65-4BCB-8332-D7A49C5CA392}"/>
              </a:ext>
            </a:extLst>
          </p:cNvPr>
          <p:cNvSpPr txBox="1"/>
          <p:nvPr/>
        </p:nvSpPr>
        <p:spPr>
          <a:xfrm>
            <a:off x="5436096" y="4941168"/>
            <a:ext cx="7258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59C4131-9E7F-485C-B704-ED4950F6B113}"/>
              </a:ext>
            </a:extLst>
          </p:cNvPr>
          <p:cNvSpPr txBox="1"/>
          <p:nvPr/>
        </p:nvSpPr>
        <p:spPr>
          <a:xfrm>
            <a:off x="395536" y="5154141"/>
            <a:ext cx="8496944" cy="17312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Figure S1. Temperament while moving to the body weight scale and during the weighing in GCs (</a:t>
            </a:r>
            <a:r>
              <a:rPr lang="ja-JP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◆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) and CCs (</a:t>
            </a:r>
            <a:r>
              <a:rPr lang="ja-JP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◇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)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he horizontal axis shows the sampling day after the start of grazing, and day 0 (0) represents the day the cattle were moved to a pasture.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AdvTimes"/>
                <a:cs typeface="Times New Roman" panose="02020603050405020304" pitchFamily="18" charset="0"/>
              </a:rPr>
              <a:t>Data are presented as the means ± SEM. A)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The scoring of resistance during movement to the body weight scale, B) the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visual analog scale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(VAS) score for head movement, C)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he VAS score for tail flicking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, D)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the VAS score for walking/stepping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AdvTimes"/>
                <a:cs typeface="Times New Roman" panose="02020603050405020304" pitchFamily="18" charset="0"/>
              </a:rPr>
              <a:t>,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and E) the VAS score for overall movement.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AdvTimes"/>
                <a:cs typeface="Times New Roman" panose="02020603050405020304" pitchFamily="18" charset="0"/>
              </a:rPr>
              <a:t>T = Treatment: a significant difference between treatments (GC vs CC), S = sampling day: a significant difference between sampling days (0, 38, 52, 72, and 86), T × S = treatment × sampling day interaction: a significant difference in the interaction of treatment × sampling day. Differences were considered significant at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P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AdvTimes"/>
                <a:cs typeface="Times New Roman" panose="02020603050405020304" pitchFamily="18" charset="0"/>
              </a:rPr>
              <a:t> &lt; 0.05.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A tendency towards significance was indicated by 0.05 &lt;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P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&lt; 0.1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  <a:p>
            <a:endParaRPr kumimoji="1"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33041732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/>
          <p:cNvGrpSpPr/>
          <p:nvPr/>
        </p:nvGrpSpPr>
        <p:grpSpPr>
          <a:xfrm>
            <a:off x="1038526" y="266433"/>
            <a:ext cx="6850924" cy="4458711"/>
            <a:chOff x="-16811" y="0"/>
            <a:chExt cx="11301489" cy="5900755"/>
          </a:xfrm>
        </p:grpSpPr>
        <p:graphicFrame>
          <p:nvGraphicFramePr>
            <p:cNvPr id="4" name="グラフ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38757851"/>
                </p:ext>
              </p:extLst>
            </p:nvPr>
          </p:nvGraphicFramePr>
          <p:xfrm>
            <a:off x="3735188" y="2848673"/>
            <a:ext cx="3762376" cy="305208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グラフ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69580863"/>
                </p:ext>
              </p:extLst>
            </p:nvPr>
          </p:nvGraphicFramePr>
          <p:xfrm>
            <a:off x="-16811" y="0"/>
            <a:ext cx="3774744" cy="30598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グラフ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23205341"/>
                </p:ext>
              </p:extLst>
            </p:nvPr>
          </p:nvGraphicFramePr>
          <p:xfrm>
            <a:off x="3735188" y="3896"/>
            <a:ext cx="3762375" cy="305208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グラフ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38903391"/>
                </p:ext>
              </p:extLst>
            </p:nvPr>
          </p:nvGraphicFramePr>
          <p:xfrm>
            <a:off x="7509933" y="3896"/>
            <a:ext cx="3774745" cy="305208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8" name="グラフ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31214732"/>
                </p:ext>
              </p:extLst>
            </p:nvPr>
          </p:nvGraphicFramePr>
          <p:xfrm>
            <a:off x="-15815" y="2862281"/>
            <a:ext cx="3762375" cy="303847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B75C614-DBA4-4161-9735-3BABB180D415}"/>
              </a:ext>
            </a:extLst>
          </p:cNvPr>
          <p:cNvSpPr txBox="1"/>
          <p:nvPr/>
        </p:nvSpPr>
        <p:spPr>
          <a:xfrm>
            <a:off x="683568" y="4797152"/>
            <a:ext cx="7560840" cy="1723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Figure S2. Temperament during handling in GCs (</a:t>
            </a:r>
            <a:r>
              <a:rPr lang="ja-JP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◆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) and CCs (</a:t>
            </a:r>
            <a:r>
              <a:rPr lang="ja-JP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◇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)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he horizontal axis shows the sampling day after the start of grazing, and day 0 (0) represents the day the cattle were moved to a pasture.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AdvTimes"/>
                <a:cs typeface="Times New Roman" panose="02020603050405020304" pitchFamily="18" charset="0"/>
              </a:rPr>
              <a:t>Data are presented as the means ± SEM. 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A) The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visual analog scale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(VAS) score for head movement, B) The VAS score for tail flicking, C) The VAS score for walking/stepping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, D) 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he VAS score for rope tension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AdvTimes"/>
                <a:cs typeface="Times New Roman" panose="02020603050405020304" pitchFamily="18" charset="0"/>
              </a:rPr>
              <a:t>, and E)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The VAS score for overall movement.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AdvTimes"/>
                <a:cs typeface="Times New Roman" panose="02020603050405020304" pitchFamily="18" charset="0"/>
              </a:rPr>
              <a:t>T = Treatment: a significant difference between treatments (GC vs CC), S = sampling day: a significant difference between sampling days (0, 38, 52, 72, and 86), T × S = treatment × sampling day interaction: a significant difference in the interaction of treatment × sampling day. Differences were considered significant at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P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AdvTimes"/>
                <a:cs typeface="Times New Roman" panose="02020603050405020304" pitchFamily="18" charset="0"/>
              </a:rPr>
              <a:t> &lt; 0.05.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A tendency towards significance was indicated by 0.05 &lt;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P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&lt; 0.1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  <a:p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63637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1218293" y="116632"/>
            <a:ext cx="6707414" cy="4680520"/>
            <a:chOff x="10909" y="0"/>
            <a:chExt cx="11245927" cy="6220845"/>
          </a:xfrm>
        </p:grpSpPr>
        <p:graphicFrame>
          <p:nvGraphicFramePr>
            <p:cNvPr id="3" name="グラフ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39583449"/>
                </p:ext>
              </p:extLst>
            </p:nvPr>
          </p:nvGraphicFramePr>
          <p:xfrm>
            <a:off x="10909" y="0"/>
            <a:ext cx="3762376" cy="30384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" name="グラフ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42912025"/>
                </p:ext>
              </p:extLst>
            </p:nvPr>
          </p:nvGraphicFramePr>
          <p:xfrm>
            <a:off x="3712790" y="3147891"/>
            <a:ext cx="3774743" cy="30384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" name="グラフ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34863882"/>
                </p:ext>
              </p:extLst>
            </p:nvPr>
          </p:nvGraphicFramePr>
          <p:xfrm>
            <a:off x="3728283" y="22117"/>
            <a:ext cx="3762375" cy="30384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6" name="グラフ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62953450"/>
                </p:ext>
              </p:extLst>
            </p:nvPr>
          </p:nvGraphicFramePr>
          <p:xfrm>
            <a:off x="7469725" y="10911"/>
            <a:ext cx="3774743" cy="303847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7" name="グラフ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98169964"/>
                </p:ext>
              </p:extLst>
            </p:nvPr>
          </p:nvGraphicFramePr>
          <p:xfrm>
            <a:off x="10909" y="3121848"/>
            <a:ext cx="3762375" cy="305208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9" name="グラフ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93637730"/>
                </p:ext>
              </p:extLst>
            </p:nvPr>
          </p:nvGraphicFramePr>
          <p:xfrm>
            <a:off x="7487534" y="3168762"/>
            <a:ext cx="3769302" cy="305208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</p:grp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7CD854D-6294-40C6-AEEF-17A9B4D06036}"/>
              </a:ext>
            </a:extLst>
          </p:cNvPr>
          <p:cNvSpPr txBox="1"/>
          <p:nvPr/>
        </p:nvSpPr>
        <p:spPr>
          <a:xfrm>
            <a:off x="755576" y="4653136"/>
            <a:ext cx="7632848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Figure S3. Temperament traits while moving to the stock for blood sampling, while in the device, and during blood sampling in GCs (</a:t>
            </a:r>
            <a:r>
              <a:rPr lang="ja-JP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◆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) and CCs (</a:t>
            </a:r>
            <a:r>
              <a:rPr lang="ja-JP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◇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)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he horizontal axis shows the sampling day after the start of grazing, and day 0 (0) represents the day the cattle were moved to a pasture.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AdvTimes"/>
                <a:cs typeface="Times New Roman" panose="02020603050405020304" pitchFamily="18" charset="0"/>
              </a:rPr>
              <a:t>Data are presented as the means ± SEM. A)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The score for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resistance 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while moving to the stock for blood sampling, B) the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visual analog scale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(VAS) score for head movement, C) the VAS score for tail flicking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, D) 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he VAS score for walking/stepping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, 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E) the VAS score for overall movement,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F)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the score for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resistance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during blood sampling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AdvTimes"/>
                <a:cs typeface="Times New Roman" panose="02020603050405020304" pitchFamily="18" charset="0"/>
              </a:rPr>
              <a:t>.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AdvTimes"/>
                <a:cs typeface="Times New Roman" panose="02020603050405020304" pitchFamily="18" charset="0"/>
              </a:rPr>
              <a:t>T = Treatment: a significant difference between treatments (GC vs CC), S = sampling day: a significant difference between sampling days (0, 38, 52, 72, and 86), T × S = treatment × sampling day interaction: a significant difference in the interaction of treatment × sampling day. Differences were considered significant at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P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AdvTimes"/>
                <a:cs typeface="Times New Roman" panose="02020603050405020304" pitchFamily="18" charset="0"/>
              </a:rPr>
              <a:t> &lt; 0.05.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A tendency towards significance was indicated by 0.05 &lt;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P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 &lt; 0.1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ゴシック" panose="020B0609070205080204" pitchFamily="49" charset="-128"/>
              <a:cs typeface="Times New Roman" panose="02020603050405020304" pitchFamily="18" charset="0"/>
            </a:endParaRPr>
          </a:p>
          <a:p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023E7B1-B975-42D3-9E64-958DF4715673}"/>
              </a:ext>
            </a:extLst>
          </p:cNvPr>
          <p:cNvSpPr txBox="1"/>
          <p:nvPr/>
        </p:nvSpPr>
        <p:spPr>
          <a:xfrm>
            <a:off x="7504279" y="4448218"/>
            <a:ext cx="7258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7214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3</TotalTime>
  <Words>975</Words>
  <Application>Microsoft Office PowerPoint</Application>
  <PresentationFormat>画面に合わせる (4:3)</PresentationFormat>
  <Paragraphs>89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​​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10</dc:creator>
  <cp:lastModifiedBy>Noriaki Nakajima</cp:lastModifiedBy>
  <cp:revision>70</cp:revision>
  <dcterms:created xsi:type="dcterms:W3CDTF">2018-09-04T02:16:35Z</dcterms:created>
  <dcterms:modified xsi:type="dcterms:W3CDTF">2021-06-27T13:05:24Z</dcterms:modified>
</cp:coreProperties>
</file>